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png" ContentType="image/png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5.jpeg" ContentType="image/jpe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29.jpeg" ContentType="image/jpeg"/>
  <Override PartName="/ppt/media/image28.png" ContentType="image/png"/>
  <Override PartName="/ppt/media/image1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8800425" cy="180006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86750-22B0-4B50-AC17-807A1DC743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248410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979280" y="10756800"/>
            <a:ext cx="248410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4D2A9-D4EA-4BE4-9CDD-7DD4F27F86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708160" y="479088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979280" y="1075680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708160" y="1075680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14036-7F02-4CA3-9281-2E0DE5F6EF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79984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378080" y="4790880"/>
            <a:ext cx="79984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776880" y="4790880"/>
            <a:ext cx="79984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979280" y="10756800"/>
            <a:ext cx="79984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378080" y="10756800"/>
            <a:ext cx="79984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776880" y="10756800"/>
            <a:ext cx="79984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76D81-91B5-44AA-A927-5AC3FDE5DC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979280" y="4790880"/>
            <a:ext cx="24841080" cy="1142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361"/>
              </a:spcBef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43AB8-3FAC-4E35-A13A-72F740D8D0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24841080" cy="1142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210EA-4E61-4076-93B1-0A9C58B1A7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12122280" cy="1142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708160" y="4790880"/>
            <a:ext cx="12122280" cy="1142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B4B82-E34B-4248-AB17-735932B667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A121E-30D9-4E16-A66A-CF1FDE82AE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979280" y="958680"/>
            <a:ext cx="24841080" cy="161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361"/>
              </a:spcBef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EDA0A-35A9-461E-8F93-4909560AFB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708160" y="4790880"/>
            <a:ext cx="12122280" cy="1142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979280" y="1075680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3FE26-5877-4933-BA6A-C04A709E53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12122280" cy="1142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708160" y="479088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708160" y="1075680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CF1C8-DD36-4BDE-A9A5-2CB9481D02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979280" y="479088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708160" y="4790880"/>
            <a:ext cx="121222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979280" y="10756800"/>
            <a:ext cx="24841080" cy="54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2361"/>
              </a:spcBef>
              <a:buNone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C2801-6343-426F-BED7-60BA72CD6D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979280" y="958680"/>
            <a:ext cx="24841080" cy="347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10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10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979280" y="4790880"/>
            <a:ext cx="24841080" cy="1142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9640" indent="-53964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  <a:p>
            <a:pPr lvl="1" marL="1619280" indent="-53964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  <a:p>
            <a:pPr lvl="2" marL="2698920" indent="-54000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  <a:p>
            <a:pPr lvl="3" marL="3780000" indent="-54000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  <a:p>
            <a:pPr lvl="4" marL="4859280" indent="-53964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  <a:p>
            <a:pPr lvl="5" marL="4859280" indent="-53964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  <a:p>
            <a:pPr lvl="6" marL="4859280" indent="-539640">
              <a:lnSpc>
                <a:spcPct val="90000"/>
              </a:lnSpc>
              <a:spcBef>
                <a:spcPts val="2361"/>
              </a:spcBef>
              <a:buClr>
                <a:srgbClr val="000000"/>
              </a:buClr>
              <a:buFont typeface="Arial"/>
              <a:buChar char="•"/>
              <a:tabLst>
                <a:tab algn="l" pos="2158920"/>
                <a:tab algn="l" pos="4317840"/>
                <a:tab algn="l" pos="6477120"/>
                <a:tab algn="l" pos="8636040"/>
                <a:tab algn="l" pos="1079496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979640" y="16684200"/>
            <a:ext cx="6480000" cy="95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l-GR" sz="2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2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540360" y="16684200"/>
            <a:ext cx="9718920" cy="95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0340720" y="16684200"/>
            <a:ext cx="6480000" cy="95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l-GR" sz="2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4A8E02E-02B8-4002-8986-5C94B5C34868}" type="slidenum">
              <a:rPr b="0" lang="el-GR" sz="2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18.png"/><Relationship Id="rId21" Type="http://schemas.openxmlformats.org/officeDocument/2006/relationships/image" Target="../media/image18.png"/><Relationship Id="rId22" Type="http://schemas.openxmlformats.org/officeDocument/2006/relationships/image" Target="../media/image18.png"/><Relationship Id="rId23" Type="http://schemas.openxmlformats.org/officeDocument/2006/relationships/image" Target="../media/image20.png"/><Relationship Id="rId24" Type="http://schemas.openxmlformats.org/officeDocument/2006/relationships/image" Target="../media/image21.png"/><Relationship Id="rId25" Type="http://schemas.openxmlformats.org/officeDocument/2006/relationships/image" Target="../media/image22.png"/><Relationship Id="rId26" Type="http://schemas.openxmlformats.org/officeDocument/2006/relationships/image" Target="../media/image23.png"/><Relationship Id="rId27" Type="http://schemas.openxmlformats.org/officeDocument/2006/relationships/image" Target="../media/image24.png"/><Relationship Id="rId28" Type="http://schemas.openxmlformats.org/officeDocument/2006/relationships/image" Target="../media/image25.png"/><Relationship Id="rId29" Type="http://schemas.openxmlformats.org/officeDocument/2006/relationships/image" Target="../media/image24.png"/><Relationship Id="rId30" Type="http://schemas.openxmlformats.org/officeDocument/2006/relationships/image" Target="../media/image26.png"/><Relationship Id="rId31" Type="http://schemas.openxmlformats.org/officeDocument/2006/relationships/image" Target="../media/image27.png"/><Relationship Id="rId32" Type="http://schemas.openxmlformats.org/officeDocument/2006/relationships/image" Target="../media/image28.png"/><Relationship Id="rId33" Type="http://schemas.openxmlformats.org/officeDocument/2006/relationships/image" Target="../media/image29.jpeg"/><Relationship Id="rId3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Ομάδα 9"/>
          <p:cNvGrpSpPr/>
          <p:nvPr/>
        </p:nvGrpSpPr>
        <p:grpSpPr>
          <a:xfrm>
            <a:off x="8170920" y="2467080"/>
            <a:ext cx="1665720" cy="2313000"/>
            <a:chOff x="8170920" y="2467080"/>
            <a:chExt cx="1665720" cy="2313000"/>
          </a:xfrm>
        </p:grpSpPr>
        <p:grpSp>
          <p:nvGrpSpPr>
            <p:cNvPr id="42" name="Group 207"/>
            <p:cNvGrpSpPr/>
            <p:nvPr/>
          </p:nvGrpSpPr>
          <p:grpSpPr>
            <a:xfrm>
              <a:off x="9285480" y="4338360"/>
              <a:ext cx="301680" cy="241200"/>
              <a:chOff x="9285480" y="4338360"/>
              <a:chExt cx="301680" cy="241200"/>
            </a:xfrm>
          </p:grpSpPr>
          <p:sp>
            <p:nvSpPr>
              <p:cNvPr id="43" name="Straight Connector 228"/>
              <p:cNvSpPr/>
              <p:nvPr/>
            </p:nvSpPr>
            <p:spPr>
              <a:xfrm flipH="1" flipV="1">
                <a:off x="9285480" y="4338360"/>
                <a:ext cx="162000" cy="101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" name="Straight Connector 229"/>
              <p:cNvSpPr/>
              <p:nvPr/>
            </p:nvSpPr>
            <p:spPr>
              <a:xfrm flipV="1">
                <a:off x="9445680" y="4363560"/>
                <a:ext cx="141480" cy="74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Straight Connector 230"/>
              <p:cNvSpPr/>
              <p:nvPr/>
            </p:nvSpPr>
            <p:spPr>
              <a:xfrm flipH="1">
                <a:off x="9411840" y="4426200"/>
                <a:ext cx="4680" cy="153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6" name="Group 208"/>
            <p:cNvGrpSpPr/>
            <p:nvPr/>
          </p:nvGrpSpPr>
          <p:grpSpPr>
            <a:xfrm>
              <a:off x="9576000" y="3215520"/>
              <a:ext cx="260640" cy="272160"/>
              <a:chOff x="9576000" y="3215520"/>
              <a:chExt cx="260640" cy="272160"/>
            </a:xfrm>
          </p:grpSpPr>
          <p:sp>
            <p:nvSpPr>
              <p:cNvPr id="47" name="Straight Connector 225"/>
              <p:cNvSpPr/>
              <p:nvPr/>
            </p:nvSpPr>
            <p:spPr>
              <a:xfrm flipH="1">
                <a:off x="9576000" y="3387960"/>
                <a:ext cx="182520" cy="66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440" bIns="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Straight Connector 226"/>
              <p:cNvSpPr/>
              <p:nvPr/>
            </p:nvSpPr>
            <p:spPr>
              <a:xfrm flipV="1">
                <a:off x="9752400" y="3215520"/>
                <a:ext cx="23760" cy="169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Straight Connector 227"/>
              <p:cNvSpPr/>
              <p:nvPr/>
            </p:nvSpPr>
            <p:spPr>
              <a:xfrm>
                <a:off x="9713520" y="3384360"/>
                <a:ext cx="123120" cy="103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0" name="Group 209"/>
            <p:cNvGrpSpPr/>
            <p:nvPr/>
          </p:nvGrpSpPr>
          <p:grpSpPr>
            <a:xfrm>
              <a:off x="8471520" y="2467080"/>
              <a:ext cx="260640" cy="270720"/>
              <a:chOff x="8471520" y="2467080"/>
              <a:chExt cx="260640" cy="270720"/>
            </a:xfrm>
          </p:grpSpPr>
          <p:sp>
            <p:nvSpPr>
              <p:cNvPr id="51" name="Straight Connector 222"/>
              <p:cNvSpPr/>
              <p:nvPr/>
            </p:nvSpPr>
            <p:spPr>
              <a:xfrm flipH="1">
                <a:off x="8471520" y="2646360"/>
                <a:ext cx="191160" cy="69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Straight Connector 223"/>
              <p:cNvSpPr/>
              <p:nvPr/>
            </p:nvSpPr>
            <p:spPr>
              <a:xfrm flipV="1">
                <a:off x="8636760" y="2467080"/>
                <a:ext cx="30600" cy="162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Straight Connector 224"/>
              <p:cNvSpPr/>
              <p:nvPr/>
            </p:nvSpPr>
            <p:spPr>
              <a:xfrm>
                <a:off x="8605800" y="2631240"/>
                <a:ext cx="126360" cy="10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4" name="Group 210"/>
            <p:cNvGrpSpPr/>
            <p:nvPr/>
          </p:nvGrpSpPr>
          <p:grpSpPr>
            <a:xfrm>
              <a:off x="8388720" y="4291560"/>
              <a:ext cx="256320" cy="279720"/>
              <a:chOff x="8388720" y="4291560"/>
              <a:chExt cx="256320" cy="279720"/>
            </a:xfrm>
          </p:grpSpPr>
          <p:sp>
            <p:nvSpPr>
              <p:cNvPr id="55" name="Straight Connector 219"/>
              <p:cNvSpPr/>
              <p:nvPr/>
            </p:nvSpPr>
            <p:spPr>
              <a:xfrm flipH="1" flipV="1">
                <a:off x="8474400" y="4291560"/>
                <a:ext cx="40320" cy="190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Straight Connector 220"/>
              <p:cNvSpPr/>
              <p:nvPr/>
            </p:nvSpPr>
            <p:spPr>
              <a:xfrm>
                <a:off x="8522640" y="4498560"/>
                <a:ext cx="122400" cy="55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Straight Connector 221"/>
              <p:cNvSpPr/>
              <p:nvPr/>
            </p:nvSpPr>
            <p:spPr>
              <a:xfrm flipH="1">
                <a:off x="8388720" y="4468320"/>
                <a:ext cx="100080" cy="10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" name="Freeform 20"/>
            <p:cNvGrpSpPr/>
            <p:nvPr/>
          </p:nvGrpSpPr>
          <p:grpSpPr>
            <a:xfrm>
              <a:off x="8170920" y="2585160"/>
              <a:ext cx="780840" cy="963360"/>
              <a:chOff x="8170920" y="2585160"/>
              <a:chExt cx="780840" cy="963360"/>
            </a:xfrm>
          </p:grpSpPr>
          <p:pic>
            <p:nvPicPr>
              <p:cNvPr id="59" name="Freeform 20" descr=""/>
              <p:cNvPicPr/>
              <p:nvPr/>
            </p:nvPicPr>
            <p:blipFill>
              <a:blip r:embed="rId1"/>
              <a:stretch/>
            </p:blipFill>
            <p:spPr>
              <a:xfrm>
                <a:off x="8170920" y="2585160"/>
                <a:ext cx="780840" cy="963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"/>
              <p:cNvSpPr/>
              <p:nvPr/>
            </p:nvSpPr>
            <p:spPr>
              <a:xfrm>
                <a:off x="8232120" y="2618280"/>
                <a:ext cx="669240" cy="849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1" name="Freeform 24"/>
            <p:cNvGrpSpPr/>
            <p:nvPr/>
          </p:nvGrpSpPr>
          <p:grpSpPr>
            <a:xfrm>
              <a:off x="8235360" y="3457440"/>
              <a:ext cx="962640" cy="1020600"/>
              <a:chOff x="8235360" y="3457440"/>
              <a:chExt cx="962640" cy="1020600"/>
            </a:xfrm>
          </p:grpSpPr>
          <p:pic>
            <p:nvPicPr>
              <p:cNvPr id="62" name="Freeform 24" descr=""/>
              <p:cNvPicPr/>
              <p:nvPr/>
            </p:nvPicPr>
            <p:blipFill>
              <a:blip r:embed="rId2"/>
              <a:stretch/>
            </p:blipFill>
            <p:spPr>
              <a:xfrm>
                <a:off x="8235360" y="3457440"/>
                <a:ext cx="962640" cy="1020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3" name=""/>
              <p:cNvSpPr/>
              <p:nvPr/>
            </p:nvSpPr>
            <p:spPr>
              <a:xfrm>
                <a:off x="8295120" y="3494160"/>
                <a:ext cx="850320" cy="90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4" name="Freeform 25"/>
            <p:cNvGrpSpPr/>
            <p:nvPr/>
          </p:nvGrpSpPr>
          <p:grpSpPr>
            <a:xfrm>
              <a:off x="8822520" y="2550960"/>
              <a:ext cx="886320" cy="1225800"/>
              <a:chOff x="8822520" y="2550960"/>
              <a:chExt cx="886320" cy="1225800"/>
            </a:xfrm>
          </p:grpSpPr>
          <p:pic>
            <p:nvPicPr>
              <p:cNvPr id="65" name="Freeform 25" descr=""/>
              <p:cNvPicPr/>
              <p:nvPr/>
            </p:nvPicPr>
            <p:blipFill>
              <a:blip r:embed="rId3"/>
              <a:stretch/>
            </p:blipFill>
            <p:spPr>
              <a:xfrm>
                <a:off x="8822520" y="2550960"/>
                <a:ext cx="886320" cy="1225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"/>
              <p:cNvSpPr/>
              <p:nvPr/>
            </p:nvSpPr>
            <p:spPr>
              <a:xfrm>
                <a:off x="8882280" y="2587320"/>
                <a:ext cx="771840" cy="1107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7" name="Freeform 29"/>
            <p:cNvGrpSpPr/>
            <p:nvPr/>
          </p:nvGrpSpPr>
          <p:grpSpPr>
            <a:xfrm>
              <a:off x="8672760" y="3771000"/>
              <a:ext cx="1044360" cy="1009080"/>
              <a:chOff x="8672760" y="3771000"/>
              <a:chExt cx="1044360" cy="1009080"/>
            </a:xfrm>
          </p:grpSpPr>
          <p:pic>
            <p:nvPicPr>
              <p:cNvPr id="68" name="Freeform 29" descr=""/>
              <p:cNvPicPr/>
              <p:nvPr/>
            </p:nvPicPr>
            <p:blipFill>
              <a:blip r:embed="rId4"/>
              <a:stretch/>
            </p:blipFill>
            <p:spPr>
              <a:xfrm>
                <a:off x="8776080" y="3771000"/>
                <a:ext cx="812880" cy="1009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9" name=""/>
              <p:cNvSpPr/>
              <p:nvPr/>
            </p:nvSpPr>
            <p:spPr>
              <a:xfrm rot="20448000">
                <a:off x="8769240" y="3899160"/>
                <a:ext cx="851040" cy="732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" name="Oval 215"/>
            <p:cNvSpPr/>
            <p:nvPr/>
          </p:nvSpPr>
          <p:spPr>
            <a:xfrm>
              <a:off x="8295840" y="2817360"/>
              <a:ext cx="269280" cy="205560"/>
            </a:xfrm>
            <a:prstGeom prst="ellipse">
              <a:avLst/>
            </a:prstGeom>
            <a:solidFill>
              <a:srgbClr val="a5a5a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494000"/>
                  <a:tab algn="l" pos="2987640"/>
                  <a:tab algn="l" pos="4481640"/>
                  <a:tab algn="l" pos="5975280"/>
                  <a:tab algn="l" pos="7469280"/>
                  <a:tab algn="l" pos="8962920"/>
                  <a:tab algn="l" pos="10456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Oval 216"/>
            <p:cNvSpPr/>
            <p:nvPr/>
          </p:nvSpPr>
          <p:spPr>
            <a:xfrm>
              <a:off x="8371080" y="3991680"/>
              <a:ext cx="272520" cy="205560"/>
            </a:xfrm>
            <a:prstGeom prst="ellipse">
              <a:avLst/>
            </a:prstGeom>
            <a:solidFill>
              <a:srgbClr val="deebf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494000"/>
                  <a:tab algn="l" pos="2987640"/>
                  <a:tab algn="l" pos="4481640"/>
                  <a:tab algn="l" pos="5975280"/>
                  <a:tab algn="l" pos="7469280"/>
                  <a:tab algn="l" pos="8962920"/>
                  <a:tab algn="l" pos="10456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Oval 217"/>
            <p:cNvSpPr/>
            <p:nvPr/>
          </p:nvSpPr>
          <p:spPr>
            <a:xfrm>
              <a:off x="9130680" y="4021920"/>
              <a:ext cx="269280" cy="207360"/>
            </a:xfrm>
            <a:prstGeom prst="ellipse">
              <a:avLst/>
            </a:prstGeom>
            <a:solidFill>
              <a:srgbClr val="00b0f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494000"/>
                  <a:tab algn="l" pos="2987640"/>
                  <a:tab algn="l" pos="4481640"/>
                  <a:tab algn="l" pos="5975280"/>
                  <a:tab algn="l" pos="7469280"/>
                  <a:tab algn="l" pos="8962920"/>
                  <a:tab algn="l" pos="10456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Oval 218"/>
            <p:cNvSpPr/>
            <p:nvPr/>
          </p:nvSpPr>
          <p:spPr>
            <a:xfrm>
              <a:off x="9071640" y="2913120"/>
              <a:ext cx="271080" cy="205560"/>
            </a:xfrm>
            <a:prstGeom prst="ellipse">
              <a:avLst/>
            </a:prstGeom>
            <a:solidFill>
              <a:srgbClr val="d0cec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494000"/>
                  <a:tab algn="l" pos="2987640"/>
                  <a:tab algn="l" pos="4481640"/>
                  <a:tab algn="l" pos="5975280"/>
                  <a:tab algn="l" pos="7469280"/>
                  <a:tab algn="l" pos="8962920"/>
                  <a:tab algn="l" pos="10456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" name="TextBox 231"/>
          <p:cNvSpPr/>
          <p:nvPr/>
        </p:nvSpPr>
        <p:spPr>
          <a:xfrm>
            <a:off x="9658440" y="3683160"/>
            <a:ext cx="179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Arial"/>
              </a:rPr>
              <a:t>HAT selec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232"/>
          <p:cNvSpPr/>
          <p:nvPr/>
        </p:nvSpPr>
        <p:spPr>
          <a:xfrm>
            <a:off x="11787120" y="2630520"/>
            <a:ext cx="257832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Arial"/>
              </a:rPr>
              <a:t>Hybridoma cell cultur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" name="Εικόνα 7" descr=""/>
          <p:cNvPicPr/>
          <p:nvPr/>
        </p:nvPicPr>
        <p:blipFill>
          <a:blip r:embed="rId5"/>
          <a:srcRect l="0" t="5395" r="0" b="12726"/>
          <a:stretch/>
        </p:blipFill>
        <p:spPr>
          <a:xfrm>
            <a:off x="10557000" y="1397160"/>
            <a:ext cx="4833720" cy="1244520"/>
          </a:xfrm>
          <a:prstGeom prst="rect">
            <a:avLst/>
          </a:prstGeom>
          <a:ln w="0">
            <a:noFill/>
          </a:ln>
        </p:spPr>
      </p:pic>
      <p:grpSp>
        <p:nvGrpSpPr>
          <p:cNvPr id="77" name="Ομάδα 8"/>
          <p:cNvGrpSpPr/>
          <p:nvPr/>
        </p:nvGrpSpPr>
        <p:grpSpPr>
          <a:xfrm>
            <a:off x="4325400" y="1812960"/>
            <a:ext cx="3985200" cy="3814200"/>
            <a:chOff x="4325400" y="1812960"/>
            <a:chExt cx="3985200" cy="3814200"/>
          </a:xfrm>
        </p:grpSpPr>
        <p:grpSp>
          <p:nvGrpSpPr>
            <p:cNvPr id="78" name="Group 237"/>
            <p:cNvGrpSpPr/>
            <p:nvPr/>
          </p:nvGrpSpPr>
          <p:grpSpPr>
            <a:xfrm>
              <a:off x="4898160" y="3794400"/>
              <a:ext cx="1523160" cy="1065960"/>
              <a:chOff x="4898160" y="3794400"/>
              <a:chExt cx="1523160" cy="1065960"/>
            </a:xfrm>
          </p:grpSpPr>
          <p:sp>
            <p:nvSpPr>
              <p:cNvPr id="79" name="Freeform 3"/>
              <p:cNvSpPr/>
              <p:nvPr/>
            </p:nvSpPr>
            <p:spPr>
              <a:xfrm>
                <a:off x="4898160" y="4154400"/>
                <a:ext cx="771840" cy="455400"/>
              </a:xfrm>
              <a:prstGeom prst="pie">
                <a:avLst/>
              </a:prstGeom>
              <a:solidFill>
                <a:srgbClr val="c55a11">
                  <a:alpha val="71000"/>
                </a:srgbClr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Freeform 5"/>
              <p:cNvSpPr/>
              <p:nvPr/>
            </p:nvSpPr>
            <p:spPr>
              <a:xfrm>
                <a:off x="5846040" y="3818160"/>
                <a:ext cx="437400" cy="644040"/>
              </a:xfrm>
              <a:prstGeom prst="pie">
                <a:avLst/>
              </a:prstGeom>
              <a:solidFill>
                <a:srgbClr val="c55a11">
                  <a:alpha val="71000"/>
                </a:srgbClr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6"/>
              <p:cNvSpPr/>
              <p:nvPr/>
            </p:nvSpPr>
            <p:spPr>
              <a:xfrm rot="1197000">
                <a:off x="5209920" y="3892320"/>
                <a:ext cx="635400" cy="340920"/>
              </a:xfrm>
              <a:prstGeom prst="pie">
                <a:avLst/>
              </a:prstGeom>
              <a:solidFill>
                <a:srgbClr val="c55a11">
                  <a:alpha val="71000"/>
                </a:srgbClr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Freeform 7"/>
              <p:cNvSpPr/>
              <p:nvPr/>
            </p:nvSpPr>
            <p:spPr>
              <a:xfrm>
                <a:off x="5650920" y="4490640"/>
                <a:ext cx="770400" cy="369720"/>
              </a:xfrm>
              <a:prstGeom prst="pie">
                <a:avLst/>
              </a:prstGeom>
              <a:solidFill>
                <a:srgbClr val="c55a11">
                  <a:alpha val="71000"/>
                </a:srgbClr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Oval 273"/>
              <p:cNvSpPr/>
              <p:nvPr/>
            </p:nvSpPr>
            <p:spPr>
              <a:xfrm>
                <a:off x="5207040" y="4279680"/>
                <a:ext cx="244080" cy="247320"/>
              </a:xfrm>
              <a:prstGeom prst="ellipse">
                <a:avLst/>
              </a:prstGeom>
              <a:solidFill>
                <a:srgbClr val="ffff00"/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Oval 274"/>
              <p:cNvSpPr/>
              <p:nvPr/>
            </p:nvSpPr>
            <p:spPr>
              <a:xfrm>
                <a:off x="5819040" y="4527360"/>
                <a:ext cx="244080" cy="242640"/>
              </a:xfrm>
              <a:prstGeom prst="ellipse">
                <a:avLst/>
              </a:prstGeom>
              <a:solidFill>
                <a:srgbClr val="ffff00"/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Oval 275"/>
              <p:cNvSpPr/>
              <p:nvPr/>
            </p:nvSpPr>
            <p:spPr>
              <a:xfrm>
                <a:off x="5963400" y="3995640"/>
                <a:ext cx="244080" cy="244080"/>
              </a:xfrm>
              <a:prstGeom prst="ellipse">
                <a:avLst/>
              </a:prstGeom>
              <a:solidFill>
                <a:srgbClr val="ffff00"/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Oval 276"/>
              <p:cNvSpPr/>
              <p:nvPr/>
            </p:nvSpPr>
            <p:spPr>
              <a:xfrm>
                <a:off x="5408640" y="3927600"/>
                <a:ext cx="242280" cy="245880"/>
              </a:xfrm>
              <a:prstGeom prst="ellipse">
                <a:avLst/>
              </a:prstGeom>
              <a:solidFill>
                <a:srgbClr val="ffff00"/>
              </a:solidFill>
              <a:ln w="12600">
                <a:solidFill>
                  <a:srgbClr val="2f528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7" name="Group 238"/>
            <p:cNvGrpSpPr/>
            <p:nvPr/>
          </p:nvGrpSpPr>
          <p:grpSpPr>
            <a:xfrm>
              <a:off x="5015160" y="2258640"/>
              <a:ext cx="1482480" cy="1338480"/>
              <a:chOff x="5015160" y="2258640"/>
              <a:chExt cx="1482480" cy="1338480"/>
            </a:xfrm>
          </p:grpSpPr>
          <p:grpSp>
            <p:nvGrpSpPr>
              <p:cNvPr id="88" name="Group 243"/>
              <p:cNvGrpSpPr/>
              <p:nvPr/>
            </p:nvGrpSpPr>
            <p:grpSpPr>
              <a:xfrm>
                <a:off x="6231960" y="3171240"/>
                <a:ext cx="265680" cy="291600"/>
                <a:chOff x="6231960" y="3171240"/>
                <a:chExt cx="265680" cy="291600"/>
              </a:xfrm>
            </p:grpSpPr>
            <p:sp>
              <p:nvSpPr>
                <p:cNvPr id="89" name="Straight Connector 266"/>
                <p:cNvSpPr/>
                <p:nvPr/>
              </p:nvSpPr>
              <p:spPr>
                <a:xfrm flipH="1" flipV="1">
                  <a:off x="6231960" y="3171240"/>
                  <a:ext cx="78480" cy="147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" name="Straight Connector 267"/>
                <p:cNvSpPr/>
                <p:nvPr/>
              </p:nvSpPr>
              <p:spPr>
                <a:xfrm flipH="1">
                  <a:off x="6236640" y="3321000"/>
                  <a:ext cx="106920" cy="1418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" name="Straight Connector 268"/>
                <p:cNvSpPr/>
                <p:nvPr/>
              </p:nvSpPr>
              <p:spPr>
                <a:xfrm flipV="1">
                  <a:off x="6324120" y="3288240"/>
                  <a:ext cx="17352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2" name="Group 244"/>
              <p:cNvGrpSpPr/>
              <p:nvPr/>
            </p:nvGrpSpPr>
            <p:grpSpPr>
              <a:xfrm>
                <a:off x="6133320" y="2258640"/>
                <a:ext cx="275040" cy="305640"/>
                <a:chOff x="6133320" y="2258640"/>
                <a:chExt cx="275040" cy="305640"/>
              </a:xfrm>
            </p:grpSpPr>
            <p:sp>
              <p:nvSpPr>
                <p:cNvPr id="93" name="Straight Connector 263"/>
                <p:cNvSpPr/>
                <p:nvPr/>
              </p:nvSpPr>
              <p:spPr>
                <a:xfrm flipH="1">
                  <a:off x="6154560" y="2401560"/>
                  <a:ext cx="86400" cy="162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" name="Straight Connector 264"/>
                <p:cNvSpPr/>
                <p:nvPr/>
              </p:nvSpPr>
              <p:spPr>
                <a:xfrm flipH="1" flipV="1">
                  <a:off x="6133320" y="2258640"/>
                  <a:ext cx="104040" cy="131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" name="Straight Connector 265"/>
                <p:cNvSpPr/>
                <p:nvPr/>
              </p:nvSpPr>
              <p:spPr>
                <a:xfrm>
                  <a:off x="6240600" y="2401920"/>
                  <a:ext cx="167760" cy="4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96" name="Group 245"/>
              <p:cNvGrpSpPr/>
              <p:nvPr/>
            </p:nvGrpSpPr>
            <p:grpSpPr>
              <a:xfrm>
                <a:off x="5171040" y="2406960"/>
                <a:ext cx="312120" cy="259920"/>
                <a:chOff x="5171040" y="2406960"/>
                <a:chExt cx="312120" cy="259920"/>
              </a:xfrm>
            </p:grpSpPr>
            <p:sp>
              <p:nvSpPr>
                <p:cNvPr id="97" name="Straight Connector 260"/>
                <p:cNvSpPr/>
                <p:nvPr/>
              </p:nvSpPr>
              <p:spPr>
                <a:xfrm>
                  <a:off x="5328000" y="2475360"/>
                  <a:ext cx="0" cy="191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Straight Connector 261"/>
                <p:cNvSpPr/>
                <p:nvPr/>
              </p:nvSpPr>
              <p:spPr>
                <a:xfrm flipH="1" flipV="1">
                  <a:off x="5171040" y="2406960"/>
                  <a:ext cx="156960" cy="680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Straight Connector 262"/>
                <p:cNvSpPr/>
                <p:nvPr/>
              </p:nvSpPr>
              <p:spPr>
                <a:xfrm flipV="1">
                  <a:off x="5328000" y="2409480"/>
                  <a:ext cx="155160" cy="680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00" name="Group 246"/>
              <p:cNvGrpSpPr/>
              <p:nvPr/>
            </p:nvGrpSpPr>
            <p:grpSpPr>
              <a:xfrm>
                <a:off x="5015160" y="2499120"/>
                <a:ext cx="1355760" cy="1098000"/>
                <a:chOff x="5015160" y="2499120"/>
                <a:chExt cx="1355760" cy="1098000"/>
              </a:xfrm>
            </p:grpSpPr>
            <p:grpSp>
              <p:nvGrpSpPr>
                <p:cNvPr id="101" name="Group 247"/>
                <p:cNvGrpSpPr/>
                <p:nvPr/>
              </p:nvGrpSpPr>
              <p:grpSpPr>
                <a:xfrm>
                  <a:off x="5380200" y="3324960"/>
                  <a:ext cx="262080" cy="272160"/>
                  <a:chOff x="5380200" y="3324960"/>
                  <a:chExt cx="262080" cy="272160"/>
                </a:xfrm>
              </p:grpSpPr>
              <p:sp>
                <p:nvSpPr>
                  <p:cNvPr id="102" name="Straight Connector 257"/>
                  <p:cNvSpPr/>
                  <p:nvPr/>
                </p:nvSpPr>
                <p:spPr>
                  <a:xfrm flipH="1" flipV="1">
                    <a:off x="5380200" y="3324960"/>
                    <a:ext cx="111600" cy="1429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3" name="Straight Connector 258"/>
                  <p:cNvSpPr/>
                  <p:nvPr/>
                </p:nvSpPr>
                <p:spPr>
                  <a:xfrm flipV="1">
                    <a:off x="5482800" y="3418200"/>
                    <a:ext cx="159480" cy="327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040" bIns="-140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4" name="Straight Connector 259"/>
                  <p:cNvSpPr/>
                  <p:nvPr/>
                </p:nvSpPr>
                <p:spPr>
                  <a:xfrm flipH="1">
                    <a:off x="5385600" y="3450240"/>
                    <a:ext cx="70200" cy="1468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05" name="Group 248"/>
                <p:cNvGrpSpPr/>
                <p:nvPr/>
              </p:nvGrpSpPr>
              <p:grpSpPr>
                <a:xfrm>
                  <a:off x="5015160" y="2499120"/>
                  <a:ext cx="1355760" cy="838800"/>
                  <a:chOff x="5015160" y="2499120"/>
                  <a:chExt cx="1355760" cy="838800"/>
                </a:xfrm>
              </p:grpSpPr>
              <p:grpSp>
                <p:nvGrpSpPr>
                  <p:cNvPr id="106" name="Oval 249"/>
                  <p:cNvGrpSpPr/>
                  <p:nvPr/>
                </p:nvGrpSpPr>
                <p:grpSpPr>
                  <a:xfrm>
                    <a:off x="5105160" y="2615760"/>
                    <a:ext cx="658080" cy="403560"/>
                    <a:chOff x="5105160" y="2615760"/>
                    <a:chExt cx="658080" cy="403560"/>
                  </a:xfrm>
                </p:grpSpPr>
                <p:pic>
                  <p:nvPicPr>
                    <p:cNvPr id="107" name="Oval 249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105160" y="2615760"/>
                      <a:ext cx="658080" cy="403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108" name=""/>
                    <p:cNvSpPr/>
                    <p:nvPr/>
                  </p:nvSpPr>
                  <p:spPr>
                    <a:xfrm>
                      <a:off x="5240880" y="2692080"/>
                      <a:ext cx="391680" cy="209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1494000"/>
                          <a:tab algn="l" pos="2987640"/>
                          <a:tab algn="l" pos="4481640"/>
                          <a:tab algn="l" pos="5975280"/>
                          <a:tab algn="l" pos="7469280"/>
                          <a:tab algn="l" pos="8962920"/>
                          <a:tab algn="l" pos="104569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109" name="Oval 250"/>
                  <p:cNvGrpSpPr/>
                  <p:nvPr/>
                </p:nvGrpSpPr>
                <p:grpSpPr>
                  <a:xfrm>
                    <a:off x="5015160" y="2934360"/>
                    <a:ext cx="658080" cy="403560"/>
                    <a:chOff x="5015160" y="2934360"/>
                    <a:chExt cx="658080" cy="403560"/>
                  </a:xfrm>
                </p:grpSpPr>
                <p:pic>
                  <p:nvPicPr>
                    <p:cNvPr id="110" name="Oval 250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5015160" y="2934360"/>
                      <a:ext cx="658080" cy="403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111" name=""/>
                    <p:cNvSpPr/>
                    <p:nvPr/>
                  </p:nvSpPr>
                  <p:spPr>
                    <a:xfrm>
                      <a:off x="5150880" y="3008160"/>
                      <a:ext cx="391680" cy="209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1494000"/>
                          <a:tab algn="l" pos="2987640"/>
                          <a:tab algn="l" pos="4481640"/>
                          <a:tab algn="l" pos="5975280"/>
                          <a:tab algn="l" pos="7469280"/>
                          <a:tab algn="l" pos="8962920"/>
                          <a:tab algn="l" pos="104569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112" name="Oval 251"/>
                  <p:cNvGrpSpPr/>
                  <p:nvPr/>
                </p:nvGrpSpPr>
                <p:grpSpPr>
                  <a:xfrm>
                    <a:off x="5656320" y="2897280"/>
                    <a:ext cx="663840" cy="403560"/>
                    <a:chOff x="5656320" y="2897280"/>
                    <a:chExt cx="663840" cy="403560"/>
                  </a:xfrm>
                </p:grpSpPr>
                <p:pic>
                  <p:nvPicPr>
                    <p:cNvPr id="113" name="Oval 251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656320" y="2897280"/>
                      <a:ext cx="663840" cy="403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114" name=""/>
                    <p:cNvSpPr/>
                    <p:nvPr/>
                  </p:nvSpPr>
                  <p:spPr>
                    <a:xfrm>
                      <a:off x="5794920" y="2974680"/>
                      <a:ext cx="392040" cy="209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1494000"/>
                          <a:tab algn="l" pos="2987640"/>
                          <a:tab algn="l" pos="4481640"/>
                          <a:tab algn="l" pos="5975280"/>
                          <a:tab algn="l" pos="7469280"/>
                          <a:tab algn="l" pos="8962920"/>
                          <a:tab algn="l" pos="104569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115" name="Oval 252"/>
                  <p:cNvGrpSpPr/>
                  <p:nvPr/>
                </p:nvGrpSpPr>
                <p:grpSpPr>
                  <a:xfrm>
                    <a:off x="5712840" y="2499120"/>
                    <a:ext cx="658080" cy="403560"/>
                    <a:chOff x="5712840" y="2499120"/>
                    <a:chExt cx="658080" cy="403560"/>
                  </a:xfrm>
                </p:grpSpPr>
                <p:pic>
                  <p:nvPicPr>
                    <p:cNvPr id="116" name="Oval 252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5712840" y="2499120"/>
                      <a:ext cx="658080" cy="403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117" name=""/>
                    <p:cNvSpPr/>
                    <p:nvPr/>
                  </p:nvSpPr>
                  <p:spPr>
                    <a:xfrm>
                      <a:off x="5848200" y="2574000"/>
                      <a:ext cx="391680" cy="209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1494000"/>
                          <a:tab algn="l" pos="2987640"/>
                          <a:tab algn="l" pos="4481640"/>
                          <a:tab algn="l" pos="5975280"/>
                          <a:tab algn="l" pos="7469280"/>
                          <a:tab algn="l" pos="8962920"/>
                          <a:tab algn="l" pos="104569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118" name="Oval 253"/>
                  <p:cNvSpPr/>
                  <p:nvPr/>
                </p:nvSpPr>
                <p:spPr>
                  <a:xfrm>
                    <a:off x="5336640" y="2680200"/>
                    <a:ext cx="223920" cy="146520"/>
                  </a:xfrm>
                  <a:prstGeom prst="ellipse">
                    <a:avLst/>
                  </a:prstGeom>
                  <a:solidFill>
                    <a:srgbClr val="548235"/>
                  </a:solidFill>
                  <a:ln w="12600">
                    <a:solidFill>
                      <a:srgbClr val="2f528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494000"/>
                        <a:tab algn="l" pos="2987640"/>
                        <a:tab algn="l" pos="4481640"/>
                        <a:tab algn="l" pos="5975280"/>
                        <a:tab algn="l" pos="7469280"/>
                        <a:tab algn="l" pos="8962920"/>
                        <a:tab algn="l" pos="1045692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9" name="Oval 254"/>
                  <p:cNvSpPr/>
                  <p:nvPr/>
                </p:nvSpPr>
                <p:spPr>
                  <a:xfrm>
                    <a:off x="5931360" y="2627640"/>
                    <a:ext cx="225360" cy="139680"/>
                  </a:xfrm>
                  <a:prstGeom prst="ellipse">
                    <a:avLst/>
                  </a:prstGeom>
                  <a:solidFill>
                    <a:srgbClr val="548235"/>
                  </a:solidFill>
                  <a:ln w="12600">
                    <a:solidFill>
                      <a:srgbClr val="2f528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494000"/>
                        <a:tab algn="l" pos="2987640"/>
                        <a:tab algn="l" pos="4481640"/>
                        <a:tab algn="l" pos="5975280"/>
                        <a:tab algn="l" pos="7469280"/>
                        <a:tab algn="l" pos="8962920"/>
                        <a:tab algn="l" pos="1045692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0" name="Oval 255"/>
                  <p:cNvSpPr/>
                  <p:nvPr/>
                </p:nvSpPr>
                <p:spPr>
                  <a:xfrm>
                    <a:off x="5878800" y="2986200"/>
                    <a:ext cx="225360" cy="149040"/>
                  </a:xfrm>
                  <a:prstGeom prst="ellipse">
                    <a:avLst/>
                  </a:prstGeom>
                  <a:solidFill>
                    <a:srgbClr val="548235"/>
                  </a:solidFill>
                  <a:ln w="12600">
                    <a:solidFill>
                      <a:srgbClr val="2f528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494000"/>
                        <a:tab algn="l" pos="2987640"/>
                        <a:tab algn="l" pos="4481640"/>
                        <a:tab algn="l" pos="5975280"/>
                        <a:tab algn="l" pos="7469280"/>
                        <a:tab algn="l" pos="8962920"/>
                        <a:tab algn="l" pos="1045692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1" name="Oval 256"/>
                  <p:cNvSpPr/>
                  <p:nvPr/>
                </p:nvSpPr>
                <p:spPr>
                  <a:xfrm>
                    <a:off x="5235480" y="3023280"/>
                    <a:ext cx="225360" cy="146520"/>
                  </a:xfrm>
                  <a:prstGeom prst="ellipse">
                    <a:avLst/>
                  </a:prstGeom>
                  <a:solidFill>
                    <a:srgbClr val="548235"/>
                  </a:solidFill>
                  <a:ln w="12600">
                    <a:solidFill>
                      <a:srgbClr val="2f528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1494000"/>
                        <a:tab algn="l" pos="2987640"/>
                        <a:tab algn="l" pos="4481640"/>
                        <a:tab algn="l" pos="5975280"/>
                        <a:tab algn="l" pos="7469280"/>
                        <a:tab algn="l" pos="8962920"/>
                        <a:tab algn="l" pos="1045692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122" name="Right Brace 239"/>
            <p:cNvSpPr/>
            <p:nvPr/>
          </p:nvSpPr>
          <p:spPr>
            <a:xfrm>
              <a:off x="6703920" y="2432160"/>
              <a:ext cx="457200" cy="2345760"/>
            </a:xfrm>
            <a:custGeom>
              <a:avLst/>
              <a:gdLst>
                <a:gd name="textAreaLeft" fmla="*/ 0 w 457200"/>
                <a:gd name="textAreaRight" fmla="*/ 164880 w 457200"/>
                <a:gd name="textAreaTop" fmla="*/ 11880 h 2345760"/>
                <a:gd name="textAreaBottom" fmla="*/ 2333880 h 23457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76"/>
                    <a:pt x="10800" y="351"/>
                  </a:cubicBezTo>
                  <a:lnTo>
                    <a:pt x="10800" y="10449"/>
                  </a:lnTo>
                  <a:cubicBezTo>
                    <a:pt x="10800" y="10625"/>
                    <a:pt x="16200" y="10800"/>
                    <a:pt x="21600" y="10800"/>
                  </a:cubicBezTo>
                  <a:cubicBezTo>
                    <a:pt x="16200" y="10800"/>
                    <a:pt x="10800" y="10976"/>
                    <a:pt x="10800" y="11151"/>
                  </a:cubicBezTo>
                  <a:lnTo>
                    <a:pt x="10800" y="21249"/>
                  </a:lnTo>
                  <a:cubicBezTo>
                    <a:pt x="10800" y="21425"/>
                    <a:pt x="5400" y="21600"/>
                    <a:pt x="0" y="21600"/>
                  </a:cubicBezTo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494000"/>
                  <a:tab algn="l" pos="2987640"/>
                  <a:tab algn="l" pos="4481640"/>
                  <a:tab algn="l" pos="5975280"/>
                  <a:tab algn="l" pos="7469280"/>
                  <a:tab algn="l" pos="8962920"/>
                  <a:tab algn="l" pos="10456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240"/>
            <p:cNvSpPr/>
            <p:nvPr/>
          </p:nvSpPr>
          <p:spPr>
            <a:xfrm>
              <a:off x="4325400" y="4923360"/>
              <a:ext cx="2818800" cy="70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3X63Ag8.653 cells 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(Multiple Myeloma cells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241"/>
            <p:cNvSpPr/>
            <p:nvPr/>
          </p:nvSpPr>
          <p:spPr>
            <a:xfrm>
              <a:off x="4889880" y="1812960"/>
              <a:ext cx="20844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plenocytes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242"/>
            <p:cNvSpPr/>
            <p:nvPr/>
          </p:nvSpPr>
          <p:spPr>
            <a:xfrm>
              <a:off x="7261200" y="3065040"/>
              <a:ext cx="10494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us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6" name="TextBox 277"/>
          <p:cNvSpPr/>
          <p:nvPr/>
        </p:nvSpPr>
        <p:spPr>
          <a:xfrm>
            <a:off x="10514160" y="5373720"/>
            <a:ext cx="4975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Total Hybridoma Culture Number:</a:t>
            </a:r>
            <a:r>
              <a:rPr b="1" lang="el-GR" sz="2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 x15</a:t>
            </a:r>
            <a:r>
              <a:rPr b="1" lang="el-GR" sz="2000" spc="-1" strike="noStrike">
                <a:solidFill>
                  <a:srgbClr val="000000"/>
                </a:solidFill>
                <a:latin typeface="Calibri"/>
                <a:ea typeface="Arial"/>
              </a:rPr>
              <a:t>8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Straight Connector 278"/>
          <p:cNvSpPr/>
          <p:nvPr/>
        </p:nvSpPr>
        <p:spPr>
          <a:xfrm>
            <a:off x="10596600" y="2571840"/>
            <a:ext cx="1047600" cy="1395360"/>
          </a:xfrm>
          <a:prstGeom prst="line">
            <a:avLst/>
          </a:prstGeom>
          <a:ln w="190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283"/>
          <p:cNvSpPr/>
          <p:nvPr/>
        </p:nvSpPr>
        <p:spPr>
          <a:xfrm>
            <a:off x="20389680" y="6861240"/>
            <a:ext cx="6029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Hybridoma Clone Selection Process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285"/>
          <p:cNvSpPr/>
          <p:nvPr/>
        </p:nvSpPr>
        <p:spPr>
          <a:xfrm>
            <a:off x="24926760" y="5964120"/>
            <a:ext cx="356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SARS-CoV-2 visualisation on IH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ight Arrow 120"/>
          <p:cNvSpPr/>
          <p:nvPr/>
        </p:nvSpPr>
        <p:spPr>
          <a:xfrm flipV="1" rot="18632400">
            <a:off x="4379760" y="3628800"/>
            <a:ext cx="631800" cy="279360"/>
          </a:xfrm>
          <a:prstGeom prst="rightArrow">
            <a:avLst>
              <a:gd name="adj1" fmla="val 50000"/>
              <a:gd name="adj2" fmla="val 49828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Right Arrow 147"/>
          <p:cNvSpPr/>
          <p:nvPr/>
        </p:nvSpPr>
        <p:spPr>
          <a:xfrm>
            <a:off x="7396200" y="3446640"/>
            <a:ext cx="736560" cy="330120"/>
          </a:xfrm>
          <a:prstGeom prst="rightArrow">
            <a:avLst>
              <a:gd name="adj1" fmla="val 50000"/>
              <a:gd name="adj2" fmla="val 50036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ight Arrow 147"/>
          <p:cNvSpPr/>
          <p:nvPr/>
        </p:nvSpPr>
        <p:spPr>
          <a:xfrm>
            <a:off x="9845640" y="4046400"/>
            <a:ext cx="1500120" cy="481320"/>
          </a:xfrm>
          <a:prstGeom prst="rightArrow">
            <a:avLst>
              <a:gd name="adj1" fmla="val 50000"/>
              <a:gd name="adj2" fmla="val 49881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3" name="Ομάδα 7"/>
          <p:cNvGrpSpPr/>
          <p:nvPr/>
        </p:nvGrpSpPr>
        <p:grpSpPr>
          <a:xfrm>
            <a:off x="11642760" y="3700440"/>
            <a:ext cx="3127320" cy="1446120"/>
            <a:chOff x="11642760" y="3700440"/>
            <a:chExt cx="3127320" cy="1446120"/>
          </a:xfrm>
        </p:grpSpPr>
        <p:sp>
          <p:nvSpPr>
            <p:cNvPr id="134" name="Straight Connector 294"/>
            <p:cNvSpPr/>
            <p:nvPr/>
          </p:nvSpPr>
          <p:spPr>
            <a:xfrm>
              <a:off x="11644200" y="3966840"/>
              <a:ext cx="0" cy="869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35" name="Group 295"/>
            <p:cNvGrpSpPr/>
            <p:nvPr/>
          </p:nvGrpSpPr>
          <p:grpSpPr>
            <a:xfrm>
              <a:off x="11680920" y="3966120"/>
              <a:ext cx="3089160" cy="1087920"/>
              <a:chOff x="11680920" y="3966120"/>
              <a:chExt cx="3089160" cy="1087920"/>
            </a:xfrm>
          </p:grpSpPr>
          <p:sp>
            <p:nvSpPr>
              <p:cNvPr id="136" name="Oval 331"/>
              <p:cNvSpPr/>
              <p:nvPr/>
            </p:nvSpPr>
            <p:spPr>
              <a:xfrm>
                <a:off x="11680920" y="4658760"/>
                <a:ext cx="3076560" cy="395280"/>
              </a:xfrm>
              <a:prstGeom prst="ellipse">
                <a:avLst/>
              </a:prstGeom>
              <a:solidFill>
                <a:srgbClr val="f8cba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Straight Connector 332"/>
              <p:cNvSpPr/>
              <p:nvPr/>
            </p:nvSpPr>
            <p:spPr>
              <a:xfrm>
                <a:off x="14770080" y="3966120"/>
                <a:ext cx="0" cy="889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8" name="Group 296"/>
            <p:cNvGrpSpPr/>
            <p:nvPr/>
          </p:nvGrpSpPr>
          <p:grpSpPr>
            <a:xfrm>
              <a:off x="11642760" y="3700440"/>
              <a:ext cx="3127320" cy="1446120"/>
              <a:chOff x="11642760" y="3700440"/>
              <a:chExt cx="3127320" cy="1446120"/>
            </a:xfrm>
          </p:grpSpPr>
          <p:sp>
            <p:nvSpPr>
              <p:cNvPr id="139" name="Oval 297"/>
              <p:cNvSpPr/>
              <p:nvPr/>
            </p:nvSpPr>
            <p:spPr>
              <a:xfrm>
                <a:off x="11644200" y="3700440"/>
                <a:ext cx="3125880" cy="533160"/>
              </a:xfrm>
              <a:prstGeom prst="ellipse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Oval 298"/>
              <p:cNvSpPr/>
              <p:nvPr/>
            </p:nvSpPr>
            <p:spPr>
              <a:xfrm>
                <a:off x="11642760" y="4503600"/>
                <a:ext cx="3116520" cy="642960"/>
              </a:xfrm>
              <a:prstGeom prst="ellipse">
                <a:avLst/>
              </a:prstGeom>
              <a:solidFill>
                <a:srgbClr val="f4b183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1494000"/>
                    <a:tab algn="l" pos="2987640"/>
                    <a:tab algn="l" pos="4481640"/>
                    <a:tab algn="l" pos="5975280"/>
                    <a:tab algn="l" pos="7469280"/>
                    <a:tab algn="l" pos="8962920"/>
                    <a:tab algn="l" pos="10456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41" name="Group 299" descr=""/>
              <p:cNvPicPr/>
              <p:nvPr/>
            </p:nvPicPr>
            <p:blipFill>
              <a:blip r:embed="rId10"/>
              <a:stretch/>
            </p:blipFill>
            <p:spPr>
              <a:xfrm>
                <a:off x="11662200" y="4382280"/>
                <a:ext cx="3102840" cy="414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42" name="Group 300"/>
              <p:cNvGrpSpPr/>
              <p:nvPr/>
            </p:nvGrpSpPr>
            <p:grpSpPr>
              <a:xfrm>
                <a:off x="12379680" y="4418640"/>
                <a:ext cx="1522440" cy="595440"/>
                <a:chOff x="12379680" y="4418640"/>
                <a:chExt cx="1522440" cy="595440"/>
              </a:xfrm>
            </p:grpSpPr>
            <p:grpSp>
              <p:nvGrpSpPr>
                <p:cNvPr id="143" name="Group 301"/>
                <p:cNvGrpSpPr/>
                <p:nvPr/>
              </p:nvGrpSpPr>
              <p:grpSpPr>
                <a:xfrm>
                  <a:off x="13210920" y="4822200"/>
                  <a:ext cx="234000" cy="191880"/>
                  <a:chOff x="13210920" y="4822200"/>
                  <a:chExt cx="234000" cy="191880"/>
                </a:xfrm>
              </p:grpSpPr>
              <p:sp>
                <p:nvSpPr>
                  <p:cNvPr id="144" name="Straight Connector 326"/>
                  <p:cNvSpPr/>
                  <p:nvPr/>
                </p:nvSpPr>
                <p:spPr>
                  <a:xfrm flipV="1">
                    <a:off x="13327920" y="4822200"/>
                    <a:ext cx="27000" cy="1177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5" name="Straight Connector 327"/>
                  <p:cNvSpPr/>
                  <p:nvPr/>
                </p:nvSpPr>
                <p:spPr>
                  <a:xfrm flipH="1">
                    <a:off x="13210920" y="4938840"/>
                    <a:ext cx="117000" cy="234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46" name="Straight Connector 328"/>
                  <p:cNvSpPr/>
                  <p:nvPr/>
                </p:nvSpPr>
                <p:spPr>
                  <a:xfrm>
                    <a:off x="13350600" y="4946040"/>
                    <a:ext cx="94320" cy="68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47" name="Group 302"/>
                <p:cNvGrpSpPr/>
                <p:nvPr/>
              </p:nvGrpSpPr>
              <p:grpSpPr>
                <a:xfrm>
                  <a:off x="12379680" y="4418640"/>
                  <a:ext cx="1522440" cy="560160"/>
                  <a:chOff x="12379680" y="4418640"/>
                  <a:chExt cx="1522440" cy="560160"/>
                </a:xfrm>
              </p:grpSpPr>
              <p:grpSp>
                <p:nvGrpSpPr>
                  <p:cNvPr id="148" name="Group 303"/>
                  <p:cNvGrpSpPr/>
                  <p:nvPr/>
                </p:nvGrpSpPr>
                <p:grpSpPr>
                  <a:xfrm>
                    <a:off x="12664800" y="4809960"/>
                    <a:ext cx="240120" cy="168840"/>
                    <a:chOff x="12664800" y="4809960"/>
                    <a:chExt cx="240120" cy="168840"/>
                  </a:xfrm>
                </p:grpSpPr>
                <p:sp>
                  <p:nvSpPr>
                    <p:cNvPr id="149" name="Straight Connector 323"/>
                    <p:cNvSpPr/>
                    <p:nvPr/>
                  </p:nvSpPr>
                  <p:spPr>
                    <a:xfrm flipV="1">
                      <a:off x="12784320" y="4809960"/>
                      <a:ext cx="0" cy="11916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50" name="Straight Connector 324"/>
                    <p:cNvSpPr/>
                    <p:nvPr/>
                  </p:nvSpPr>
                  <p:spPr>
                    <a:xfrm flipH="1">
                      <a:off x="12664800" y="4929480"/>
                      <a:ext cx="119160" cy="493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520" bIns="2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51" name="Straight Connector 325"/>
                    <p:cNvSpPr/>
                    <p:nvPr/>
                  </p:nvSpPr>
                  <p:spPr>
                    <a:xfrm>
                      <a:off x="12784320" y="4929480"/>
                      <a:ext cx="120600" cy="493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520" bIns="2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152" name="Group 304"/>
                  <p:cNvGrpSpPr/>
                  <p:nvPr/>
                </p:nvGrpSpPr>
                <p:grpSpPr>
                  <a:xfrm>
                    <a:off x="12379680" y="4418640"/>
                    <a:ext cx="1522440" cy="489600"/>
                    <a:chOff x="12379680" y="4418640"/>
                    <a:chExt cx="1522440" cy="489600"/>
                  </a:xfrm>
                </p:grpSpPr>
                <p:grpSp>
                  <p:nvGrpSpPr>
                    <p:cNvPr id="153" name="Group 305"/>
                    <p:cNvGrpSpPr/>
                    <p:nvPr/>
                  </p:nvGrpSpPr>
                  <p:grpSpPr>
                    <a:xfrm>
                      <a:off x="12707640" y="4420080"/>
                      <a:ext cx="239760" cy="169200"/>
                      <a:chOff x="12707640" y="4420080"/>
                      <a:chExt cx="239760" cy="169200"/>
                    </a:xfrm>
                  </p:grpSpPr>
                  <p:sp>
                    <p:nvSpPr>
                      <p:cNvPr id="154" name="Straight Connector 320"/>
                      <p:cNvSpPr/>
                      <p:nvPr/>
                    </p:nvSpPr>
                    <p:spPr>
                      <a:xfrm>
                        <a:off x="12843720" y="4479120"/>
                        <a:ext cx="0" cy="110160"/>
                      </a:xfrm>
                      <a:prstGeom prst="line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155" name="Straight Connector 321"/>
                      <p:cNvSpPr/>
                      <p:nvPr/>
                    </p:nvSpPr>
                    <p:spPr>
                      <a:xfrm flipH="1" flipV="1">
                        <a:off x="12707640" y="4420080"/>
                        <a:ext cx="136080" cy="58680"/>
                      </a:xfrm>
                      <a:prstGeom prst="line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1880" bIns="1188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156" name="Straight Connector 322"/>
                      <p:cNvSpPr/>
                      <p:nvPr/>
                    </p:nvSpPr>
                    <p:spPr>
                      <a:xfrm flipV="1">
                        <a:off x="12843720" y="4420080"/>
                        <a:ext cx="103680" cy="58680"/>
                      </a:xfrm>
                      <a:prstGeom prst="line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11880" bIns="1188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</p:grpSp>
                <p:grpSp>
                  <p:nvGrpSpPr>
                    <p:cNvPr id="157" name="Group 306"/>
                    <p:cNvGrpSpPr/>
                    <p:nvPr/>
                  </p:nvGrpSpPr>
                  <p:grpSpPr>
                    <a:xfrm>
                      <a:off x="12379680" y="4418640"/>
                      <a:ext cx="1522440" cy="489600"/>
                      <a:chOff x="12379680" y="4418640"/>
                      <a:chExt cx="1522440" cy="489600"/>
                    </a:xfrm>
                  </p:grpSpPr>
                  <p:grpSp>
                    <p:nvGrpSpPr>
                      <p:cNvPr id="158" name="Group 307"/>
                      <p:cNvGrpSpPr/>
                      <p:nvPr/>
                    </p:nvGrpSpPr>
                    <p:grpSpPr>
                      <a:xfrm>
                        <a:off x="13575600" y="4418640"/>
                        <a:ext cx="253800" cy="159480"/>
                        <a:chOff x="13575600" y="4418640"/>
                        <a:chExt cx="253800" cy="159480"/>
                      </a:xfrm>
                    </p:grpSpPr>
                    <p:sp>
                      <p:nvSpPr>
                        <p:cNvPr id="159" name="Straight Connector 317"/>
                        <p:cNvSpPr/>
                        <p:nvPr/>
                      </p:nvSpPr>
                      <p:spPr>
                        <a:xfrm>
                          <a:off x="13648320" y="4534920"/>
                          <a:ext cx="181080" cy="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46800" bIns="-4680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60" name="Straight Connector 318"/>
                        <p:cNvSpPr/>
                        <p:nvPr/>
                      </p:nvSpPr>
                      <p:spPr>
                        <a:xfrm flipH="1">
                          <a:off x="13575600" y="4519080"/>
                          <a:ext cx="72720" cy="5904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12240" bIns="1224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61" name="Straight Connector 319"/>
                        <p:cNvSpPr/>
                        <p:nvPr/>
                      </p:nvSpPr>
                      <p:spPr>
                        <a:xfrm flipH="1" flipV="1">
                          <a:off x="13577040" y="4418640"/>
                          <a:ext cx="72720" cy="86760"/>
                        </a:xfrm>
                        <a:prstGeom prst="line">
                          <a:avLst/>
                        </a:prstGeom>
                        <a:ln w="1260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39960" bIns="3996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  <p:grpSp>
                    <p:nvGrpSpPr>
                      <p:cNvPr id="162" name="Group 308"/>
                      <p:cNvGrpSpPr/>
                      <p:nvPr/>
                    </p:nvGrpSpPr>
                    <p:grpSpPr>
                      <a:xfrm>
                        <a:off x="12379680" y="4446720"/>
                        <a:ext cx="1522440" cy="461520"/>
                        <a:chOff x="12379680" y="4446720"/>
                        <a:chExt cx="1522440" cy="461520"/>
                      </a:xfrm>
                    </p:grpSpPr>
                    <p:grpSp>
                      <p:nvGrpSpPr>
                        <p:cNvPr id="163" name="Freeform 167"/>
                        <p:cNvGrpSpPr/>
                        <p:nvPr/>
                      </p:nvGrpSpPr>
                      <p:grpSpPr>
                        <a:xfrm>
                          <a:off x="12385080" y="4648320"/>
                          <a:ext cx="694080" cy="245520"/>
                          <a:chOff x="12385080" y="4648320"/>
                          <a:chExt cx="694080" cy="245520"/>
                        </a:xfrm>
                      </p:grpSpPr>
                      <p:pic>
                        <p:nvPicPr>
                          <p:cNvPr id="164" name="Freeform 167" descr=""/>
                          <p:cNvPicPr/>
                          <p:nvPr/>
                        </p:nvPicPr>
                        <p:blipFill>
                          <a:blip r:embed="rId11"/>
                          <a:stretch/>
                        </p:blipFill>
                        <p:spPr>
                          <a:xfrm>
                            <a:off x="12385080" y="4648320"/>
                            <a:ext cx="694080" cy="245520"/>
                          </a:xfrm>
                          <a:prstGeom prst="rect">
                            <a:avLst/>
                          </a:prstGeom>
                          <a:ln w="0">
                            <a:noFill/>
                          </a:ln>
                        </p:spPr>
                      </p:pic>
                      <p:sp>
                        <p:nvSpPr>
                          <p:cNvPr id="165" name=""/>
                          <p:cNvSpPr/>
                          <p:nvPr/>
                        </p:nvSpPr>
                        <p:spPr>
                          <a:xfrm rot="16363200">
                            <a:off x="12652920" y="4461120"/>
                            <a:ext cx="159840" cy="581760"/>
                          </a:xfrm>
                          <a:prstGeom prst="rect">
                            <a:avLst/>
                          </a:prstGeom>
                          <a:noFill/>
                          <a:ln w="0">
                            <a:noFill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tabLst>
                                <a:tab algn="l" pos="0"/>
                                <a:tab algn="l" pos="1494000"/>
                                <a:tab algn="l" pos="2987640"/>
                                <a:tab algn="l" pos="4481640"/>
                                <a:tab algn="l" pos="5975280"/>
                                <a:tab algn="l" pos="7469280"/>
                                <a:tab algn="l" pos="8962920"/>
                                <a:tab algn="l" pos="10456920"/>
                              </a:tabLst>
                            </a:pPr>
                            <a:endParaRPr b="0" lang="en-US" sz="18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166" name="Freeform 168"/>
                        <p:cNvGrpSpPr/>
                        <p:nvPr/>
                      </p:nvGrpSpPr>
                      <p:grpSpPr>
                        <a:xfrm>
                          <a:off x="12989880" y="4590360"/>
                          <a:ext cx="722160" cy="317880"/>
                          <a:chOff x="12989880" y="4590360"/>
                          <a:chExt cx="722160" cy="317880"/>
                        </a:xfrm>
                      </p:grpSpPr>
                      <p:pic>
                        <p:nvPicPr>
                          <p:cNvPr id="167" name="Freeform 168" descr=""/>
                          <p:cNvPicPr/>
                          <p:nvPr/>
                        </p:nvPicPr>
                        <p:blipFill>
                          <a:blip r:embed="rId12"/>
                          <a:stretch/>
                        </p:blipFill>
                        <p:spPr>
                          <a:xfrm>
                            <a:off x="12989880" y="4590360"/>
                            <a:ext cx="722160" cy="317880"/>
                          </a:xfrm>
                          <a:prstGeom prst="rect">
                            <a:avLst/>
                          </a:prstGeom>
                          <a:ln w="0">
                            <a:noFill/>
                          </a:ln>
                        </p:spPr>
                      </p:pic>
                      <p:sp>
                        <p:nvSpPr>
                          <p:cNvPr id="168" name=""/>
                          <p:cNvSpPr/>
                          <p:nvPr/>
                        </p:nvSpPr>
                        <p:spPr>
                          <a:xfrm rot="16363200">
                            <a:off x="13254840" y="4417560"/>
                            <a:ext cx="203040" cy="621000"/>
                          </a:xfrm>
                          <a:prstGeom prst="rect">
                            <a:avLst/>
                          </a:prstGeom>
                          <a:noFill/>
                          <a:ln w="0">
                            <a:noFill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tabLst>
                                <a:tab algn="l" pos="0"/>
                                <a:tab algn="l" pos="1494000"/>
                                <a:tab algn="l" pos="2987640"/>
                                <a:tab algn="l" pos="4481640"/>
                                <a:tab algn="l" pos="5975280"/>
                                <a:tab algn="l" pos="7469280"/>
                                <a:tab algn="l" pos="8962920"/>
                                <a:tab algn="l" pos="10456920"/>
                              </a:tabLst>
                            </a:pPr>
                            <a:endParaRPr b="0" lang="en-US" sz="18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169" name="Freeform 169"/>
                        <p:cNvGrpSpPr/>
                        <p:nvPr/>
                      </p:nvGrpSpPr>
                      <p:grpSpPr>
                        <a:xfrm>
                          <a:off x="12379680" y="4476600"/>
                          <a:ext cx="873360" cy="263160"/>
                          <a:chOff x="12379680" y="4476600"/>
                          <a:chExt cx="873360" cy="263160"/>
                        </a:xfrm>
                      </p:grpSpPr>
                      <p:pic>
                        <p:nvPicPr>
                          <p:cNvPr id="170" name="Freeform 169" descr=""/>
                          <p:cNvPicPr/>
                          <p:nvPr/>
                        </p:nvPicPr>
                        <p:blipFill>
                          <a:blip r:embed="rId13"/>
                          <a:stretch/>
                        </p:blipFill>
                        <p:spPr>
                          <a:xfrm>
                            <a:off x="12379680" y="4479840"/>
                            <a:ext cx="873360" cy="259920"/>
                          </a:xfrm>
                          <a:prstGeom prst="rect">
                            <a:avLst/>
                          </a:prstGeom>
                          <a:ln w="0">
                            <a:noFill/>
                          </a:ln>
                        </p:spPr>
                      </p:pic>
                      <p:sp>
                        <p:nvSpPr>
                          <p:cNvPr id="171" name=""/>
                          <p:cNvSpPr/>
                          <p:nvPr/>
                        </p:nvSpPr>
                        <p:spPr>
                          <a:xfrm rot="16363200">
                            <a:off x="12726360" y="4206960"/>
                            <a:ext cx="184320" cy="758520"/>
                          </a:xfrm>
                          <a:prstGeom prst="rect">
                            <a:avLst/>
                          </a:prstGeom>
                          <a:noFill/>
                          <a:ln w="0">
                            <a:noFill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tabLst>
                                <a:tab algn="l" pos="0"/>
                                <a:tab algn="l" pos="1494000"/>
                                <a:tab algn="l" pos="2987640"/>
                                <a:tab algn="l" pos="4481640"/>
                                <a:tab algn="l" pos="5975280"/>
                                <a:tab algn="l" pos="7469280"/>
                                <a:tab algn="l" pos="8962920"/>
                                <a:tab algn="l" pos="10456920"/>
                              </a:tabLst>
                            </a:pPr>
                            <a:endParaRPr b="0" lang="en-US" sz="18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172" name="Freeform 170"/>
                        <p:cNvGrpSpPr/>
                        <p:nvPr/>
                      </p:nvGrpSpPr>
                      <p:grpSpPr>
                        <a:xfrm>
                          <a:off x="13258440" y="4446720"/>
                          <a:ext cx="643680" cy="343800"/>
                          <a:chOff x="13258440" y="4446720"/>
                          <a:chExt cx="643680" cy="343800"/>
                        </a:xfrm>
                      </p:grpSpPr>
                      <p:pic>
                        <p:nvPicPr>
                          <p:cNvPr id="173" name="Freeform 170" descr=""/>
                          <p:cNvPicPr/>
                          <p:nvPr/>
                        </p:nvPicPr>
                        <p:blipFill>
                          <a:blip r:embed="rId14"/>
                          <a:stretch/>
                        </p:blipFill>
                        <p:spPr>
                          <a:xfrm>
                            <a:off x="13258440" y="4516560"/>
                            <a:ext cx="643680" cy="246960"/>
                          </a:xfrm>
                          <a:prstGeom prst="rect">
                            <a:avLst/>
                          </a:prstGeom>
                          <a:ln w="0">
                            <a:noFill/>
                          </a:ln>
                        </p:spPr>
                      </p:pic>
                      <p:sp>
                        <p:nvSpPr>
                          <p:cNvPr id="174" name=""/>
                          <p:cNvSpPr/>
                          <p:nvPr/>
                        </p:nvSpPr>
                        <p:spPr>
                          <a:xfrm rot="15211200">
                            <a:off x="13481280" y="4367520"/>
                            <a:ext cx="210240" cy="501840"/>
                          </a:xfrm>
                          <a:prstGeom prst="rect">
                            <a:avLst/>
                          </a:prstGeom>
                          <a:noFill/>
                          <a:ln w="0">
                            <a:noFill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lIns="90000" rIns="90000" tIns="46800" bIns="46800" anchor="ctr">
                            <a:noAutofit/>
                          </a:bodyPr>
                          <a:p>
                            <a:pPr algn="ctr">
                              <a:tabLst>
                                <a:tab algn="l" pos="0"/>
                                <a:tab algn="l" pos="1494000"/>
                                <a:tab algn="l" pos="2987640"/>
                                <a:tab algn="l" pos="4481640"/>
                                <a:tab algn="l" pos="5975280"/>
                                <a:tab algn="l" pos="7469280"/>
                                <a:tab algn="l" pos="8962920"/>
                                <a:tab algn="l" pos="10456920"/>
                              </a:tabLst>
                            </a:pPr>
                            <a:endParaRPr b="0" lang="en-US" sz="1800" spc="-1" strike="noStrike">
                              <a:solidFill>
                                <a:srgbClr val="000000"/>
                              </a:solidFill>
                              <a:latin typeface="Calibri"/>
                            </a:endParaRPr>
                          </a:p>
                        </p:txBody>
                      </p:sp>
                    </p:grpSp>
                    <p:sp>
                      <p:nvSpPr>
                        <p:cNvPr id="175" name="Oval 313"/>
                        <p:cNvSpPr/>
                        <p:nvPr/>
                      </p:nvSpPr>
                      <p:spPr>
                        <a:xfrm rot="16363200">
                          <a:off x="12612600" y="4702680"/>
                          <a:ext cx="63720" cy="139680"/>
                        </a:xfrm>
                        <a:prstGeom prst="ellipse">
                          <a:avLst/>
                        </a:prstGeom>
                        <a:solidFill>
                          <a:srgbClr val="a5a5a5"/>
                        </a:soli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494000"/>
                              <a:tab algn="l" pos="2987640"/>
                              <a:tab algn="l" pos="4481640"/>
                              <a:tab algn="l" pos="5975280"/>
                              <a:tab algn="l" pos="7469280"/>
                              <a:tab algn="l" pos="8962920"/>
                              <a:tab algn="l" pos="10456920"/>
                            </a:tabLst>
                          </a:pPr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76" name="Oval 314"/>
                        <p:cNvSpPr/>
                        <p:nvPr/>
                      </p:nvSpPr>
                      <p:spPr>
                        <a:xfrm rot="16363200">
                          <a:off x="13419360" y="4710960"/>
                          <a:ext cx="63720" cy="141120"/>
                        </a:xfrm>
                        <a:prstGeom prst="ellipse">
                          <a:avLst/>
                        </a:prstGeom>
                        <a:solidFill>
                          <a:srgbClr val="deebf7"/>
                        </a:soli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494000"/>
                              <a:tab algn="l" pos="2987640"/>
                              <a:tab algn="l" pos="4481640"/>
                              <a:tab algn="l" pos="5975280"/>
                              <a:tab algn="l" pos="7469280"/>
                              <a:tab algn="l" pos="8962920"/>
                              <a:tab algn="l" pos="10456920"/>
                            </a:tabLst>
                          </a:pPr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77" name="Oval 315"/>
                        <p:cNvSpPr/>
                        <p:nvPr/>
                      </p:nvSpPr>
                      <p:spPr>
                        <a:xfrm rot="16363200">
                          <a:off x="13450680" y="4517640"/>
                          <a:ext cx="84960" cy="142560"/>
                        </a:xfrm>
                        <a:prstGeom prst="ellipse">
                          <a:avLst/>
                        </a:prstGeom>
                        <a:solidFill>
                          <a:srgbClr val="00b0f0"/>
                        </a:soli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494000"/>
                              <a:tab algn="l" pos="2987640"/>
                              <a:tab algn="l" pos="4481640"/>
                              <a:tab algn="l" pos="5975280"/>
                              <a:tab algn="l" pos="7469280"/>
                              <a:tab algn="l" pos="8962920"/>
                              <a:tab algn="l" pos="10456920"/>
                            </a:tabLst>
                          </a:pPr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78" name="Oval 316"/>
                        <p:cNvSpPr/>
                        <p:nvPr/>
                      </p:nvSpPr>
                      <p:spPr>
                        <a:xfrm rot="16363200">
                          <a:off x="12688200" y="4516560"/>
                          <a:ext cx="84960" cy="142560"/>
                        </a:xfrm>
                        <a:prstGeom prst="ellipse">
                          <a:avLst/>
                        </a:prstGeom>
                        <a:solidFill>
                          <a:srgbClr val="d0cece"/>
                        </a:soli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1494000"/>
                              <a:tab algn="l" pos="2987640"/>
                              <a:tab algn="l" pos="4481640"/>
                              <a:tab algn="l" pos="5975280"/>
                              <a:tab algn="l" pos="7469280"/>
                              <a:tab algn="l" pos="8962920"/>
                              <a:tab algn="l" pos="10456920"/>
                            </a:tabLst>
                          </a:pPr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</p:grpSp>
            </p:grpSp>
          </p:grpSp>
        </p:grpSp>
      </p:grpSp>
      <p:pic>
        <p:nvPicPr>
          <p:cNvPr id="179" name="Picture 388" descr=""/>
          <p:cNvPicPr/>
          <p:nvPr/>
        </p:nvPicPr>
        <p:blipFill>
          <a:blip r:embed="rId15"/>
          <a:stretch/>
        </p:blipFill>
        <p:spPr>
          <a:xfrm>
            <a:off x="21008880" y="2930400"/>
            <a:ext cx="4025880" cy="3521160"/>
          </a:xfrm>
          <a:prstGeom prst="rect">
            <a:avLst/>
          </a:prstGeom>
          <a:ln w="0">
            <a:noFill/>
          </a:ln>
        </p:spPr>
      </p:pic>
      <p:sp>
        <p:nvSpPr>
          <p:cNvPr id="180" name="TextBox 391"/>
          <p:cNvSpPr/>
          <p:nvPr/>
        </p:nvSpPr>
        <p:spPr>
          <a:xfrm>
            <a:off x="22307400" y="2219400"/>
            <a:ext cx="12668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Full Spike Protein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392"/>
          <p:cNvSpPr/>
          <p:nvPr/>
        </p:nvSpPr>
        <p:spPr>
          <a:xfrm>
            <a:off x="20389680" y="2273400"/>
            <a:ext cx="221328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Monoclonal Antibody candidates (mAb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385"/>
          <p:cNvSpPr/>
          <p:nvPr/>
        </p:nvSpPr>
        <p:spPr>
          <a:xfrm>
            <a:off x="23271120" y="2238480"/>
            <a:ext cx="16556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Secondary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A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597"/>
          <p:cNvSpPr/>
          <p:nvPr/>
        </p:nvSpPr>
        <p:spPr>
          <a:xfrm>
            <a:off x="7616880" y="4930920"/>
            <a:ext cx="23288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Hybridoma cell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Left Brace 287"/>
          <p:cNvSpPr/>
          <p:nvPr/>
        </p:nvSpPr>
        <p:spPr>
          <a:xfrm flipH="1" rot="5400000">
            <a:off x="22788000" y="4966560"/>
            <a:ext cx="406080" cy="3201840"/>
          </a:xfrm>
          <a:custGeom>
            <a:avLst/>
            <a:gdLst>
              <a:gd name="textAreaLeft" fmla="*/ 259560 w 406080"/>
              <a:gd name="textAreaRight" fmla="*/ 406440 w 406080"/>
              <a:gd name="textAreaTop" fmla="*/ 10440 h 3201840"/>
              <a:gd name="textAreaBottom" fmla="*/ 3191400 h 3201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14"/>
                  <a:pt x="10800" y="228"/>
                </a:cubicBezTo>
                <a:lnTo>
                  <a:pt x="10800" y="10572"/>
                </a:lnTo>
                <a:cubicBezTo>
                  <a:pt x="10800" y="10686"/>
                  <a:pt x="5400" y="10800"/>
                  <a:pt x="0" y="10800"/>
                </a:cubicBezTo>
                <a:cubicBezTo>
                  <a:pt x="5400" y="10800"/>
                  <a:pt x="10800" y="10914"/>
                  <a:pt x="10800" y="11028"/>
                </a:cubicBezTo>
                <a:lnTo>
                  <a:pt x="10800" y="21372"/>
                </a:lnTo>
                <a:cubicBezTo>
                  <a:pt x="10800" y="21486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5" name="Εικόνα 15" descr=""/>
          <p:cNvPicPr/>
          <p:nvPr/>
        </p:nvPicPr>
        <p:blipFill>
          <a:blip r:embed="rId16"/>
          <a:stretch/>
        </p:blipFill>
        <p:spPr>
          <a:xfrm>
            <a:off x="252360" y="1096920"/>
            <a:ext cx="3827520" cy="4087800"/>
          </a:xfrm>
          <a:prstGeom prst="rect">
            <a:avLst/>
          </a:prstGeom>
          <a:ln w="0">
            <a:noFill/>
          </a:ln>
        </p:spPr>
      </p:pic>
      <p:sp>
        <p:nvSpPr>
          <p:cNvPr id="186" name="Right Arrow 120"/>
          <p:cNvSpPr/>
          <p:nvPr/>
        </p:nvSpPr>
        <p:spPr>
          <a:xfrm flipV="1" rot="2907600">
            <a:off x="3178800" y="3843360"/>
            <a:ext cx="525240" cy="256680"/>
          </a:xfrm>
          <a:prstGeom prst="rightArrow">
            <a:avLst>
              <a:gd name="adj1" fmla="val 50000"/>
              <a:gd name="adj2" fmla="val 50124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7" name="Freeform 91"/>
          <p:cNvGrpSpPr/>
          <p:nvPr/>
        </p:nvGrpSpPr>
        <p:grpSpPr>
          <a:xfrm>
            <a:off x="3627360" y="4095720"/>
            <a:ext cx="914400" cy="366840"/>
            <a:chOff x="3627360" y="4095720"/>
            <a:chExt cx="914400" cy="366840"/>
          </a:xfrm>
        </p:grpSpPr>
        <p:pic>
          <p:nvPicPr>
            <p:cNvPr id="188" name="Freeform 91" descr=""/>
            <p:cNvPicPr/>
            <p:nvPr/>
          </p:nvPicPr>
          <p:blipFill>
            <a:blip r:embed="rId17"/>
            <a:stretch/>
          </p:blipFill>
          <p:spPr>
            <a:xfrm>
              <a:off x="3627360" y="4095720"/>
              <a:ext cx="914400" cy="366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9" name=""/>
            <p:cNvSpPr/>
            <p:nvPr/>
          </p:nvSpPr>
          <p:spPr>
            <a:xfrm>
              <a:off x="3648240" y="4113360"/>
              <a:ext cx="880920" cy="333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494000"/>
                  <a:tab algn="l" pos="2987640"/>
                  <a:tab algn="l" pos="4481640"/>
                  <a:tab algn="l" pos="5975280"/>
                  <a:tab algn="l" pos="7469280"/>
                  <a:tab algn="l" pos="8962920"/>
                  <a:tab algn="l" pos="10456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90" name="Straight Arrow Connector 596"/>
          <p:cNvCxnSpPr/>
          <p:nvPr/>
        </p:nvCxnSpPr>
        <p:spPr>
          <a:xfrm>
            <a:off x="2387160" y="1820520"/>
            <a:ext cx="462600" cy="183240"/>
          </a:xfrm>
          <a:prstGeom prst="straightConnector1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191" name="Εικόνα 2299" descr=""/>
          <p:cNvPicPr/>
          <p:nvPr/>
        </p:nvPicPr>
        <p:blipFill>
          <a:blip r:embed="rId18"/>
          <a:stretch/>
        </p:blipFill>
        <p:spPr>
          <a:xfrm>
            <a:off x="22588560" y="1197000"/>
            <a:ext cx="662040" cy="925560"/>
          </a:xfrm>
          <a:prstGeom prst="rect">
            <a:avLst/>
          </a:prstGeom>
          <a:ln w="0">
            <a:noFill/>
          </a:ln>
        </p:spPr>
      </p:pic>
      <p:pic>
        <p:nvPicPr>
          <p:cNvPr id="192" name="Εικόνα 2304" descr=""/>
          <p:cNvPicPr/>
          <p:nvPr/>
        </p:nvPicPr>
        <p:blipFill>
          <a:blip r:embed="rId19"/>
          <a:stretch/>
        </p:blipFill>
        <p:spPr>
          <a:xfrm>
            <a:off x="25236360" y="2300400"/>
            <a:ext cx="3148200" cy="3627360"/>
          </a:xfrm>
          <a:prstGeom prst="rect">
            <a:avLst/>
          </a:prstGeom>
          <a:ln w="0">
            <a:noFill/>
          </a:ln>
        </p:spPr>
      </p:pic>
      <p:pic>
        <p:nvPicPr>
          <p:cNvPr id="193" name="Εικόνα 595" descr=""/>
          <p:cNvPicPr/>
          <p:nvPr/>
        </p:nvPicPr>
        <p:blipFill>
          <a:blip r:embed="rId20"/>
          <a:stretch/>
        </p:blipFill>
        <p:spPr>
          <a:xfrm>
            <a:off x="21896280" y="5254560"/>
            <a:ext cx="387360" cy="541440"/>
          </a:xfrm>
          <a:prstGeom prst="rect">
            <a:avLst/>
          </a:prstGeom>
          <a:ln w="0">
            <a:noFill/>
          </a:ln>
        </p:spPr>
      </p:pic>
      <p:pic>
        <p:nvPicPr>
          <p:cNvPr id="194" name="Εικόνα 597" descr=""/>
          <p:cNvPicPr/>
          <p:nvPr/>
        </p:nvPicPr>
        <p:blipFill>
          <a:blip r:embed="rId21"/>
          <a:stretch/>
        </p:blipFill>
        <p:spPr>
          <a:xfrm>
            <a:off x="22833000" y="5254560"/>
            <a:ext cx="387360" cy="541440"/>
          </a:xfrm>
          <a:prstGeom prst="rect">
            <a:avLst/>
          </a:prstGeom>
          <a:ln w="0">
            <a:noFill/>
          </a:ln>
        </p:spPr>
      </p:pic>
      <p:pic>
        <p:nvPicPr>
          <p:cNvPr id="195" name="Εικόνα 598" descr=""/>
          <p:cNvPicPr/>
          <p:nvPr/>
        </p:nvPicPr>
        <p:blipFill>
          <a:blip r:embed="rId22"/>
          <a:stretch/>
        </p:blipFill>
        <p:spPr>
          <a:xfrm>
            <a:off x="23753880" y="5254560"/>
            <a:ext cx="385560" cy="541440"/>
          </a:xfrm>
          <a:prstGeom prst="rect">
            <a:avLst/>
          </a:prstGeom>
          <a:ln w="0">
            <a:noFill/>
          </a:ln>
        </p:spPr>
      </p:pic>
      <p:pic>
        <p:nvPicPr>
          <p:cNvPr id="196" name="Picture 380" descr="Icon&#10;&#10;Description automatically generated"/>
          <p:cNvPicPr/>
          <p:nvPr/>
        </p:nvPicPr>
        <p:blipFill>
          <a:blip r:embed="rId23"/>
          <a:stretch/>
        </p:blipFill>
        <p:spPr>
          <a:xfrm>
            <a:off x="21070800" y="1173240"/>
            <a:ext cx="987480" cy="1052280"/>
          </a:xfrm>
          <a:prstGeom prst="rect">
            <a:avLst/>
          </a:prstGeom>
          <a:ln w="0">
            <a:noFill/>
          </a:ln>
        </p:spPr>
      </p:pic>
      <p:pic>
        <p:nvPicPr>
          <p:cNvPr id="197" name="Εικόνα 5" descr=""/>
          <p:cNvPicPr/>
          <p:nvPr/>
        </p:nvPicPr>
        <p:blipFill>
          <a:blip r:embed="rId24"/>
          <a:stretch/>
        </p:blipFill>
        <p:spPr>
          <a:xfrm>
            <a:off x="23561640" y="880920"/>
            <a:ext cx="1587600" cy="1346400"/>
          </a:xfrm>
          <a:prstGeom prst="rect">
            <a:avLst/>
          </a:prstGeom>
          <a:ln w="0">
            <a:noFill/>
          </a:ln>
        </p:spPr>
      </p:pic>
      <p:pic>
        <p:nvPicPr>
          <p:cNvPr id="198" name="Εικόνα 207" descr=""/>
          <p:cNvPicPr/>
          <p:nvPr/>
        </p:nvPicPr>
        <p:blipFill>
          <a:blip r:embed="rId25"/>
          <a:stretch/>
        </p:blipFill>
        <p:spPr>
          <a:xfrm>
            <a:off x="22285440" y="3567240"/>
            <a:ext cx="1000080" cy="969840"/>
          </a:xfrm>
          <a:prstGeom prst="rect">
            <a:avLst/>
          </a:prstGeom>
          <a:ln w="0">
            <a:noFill/>
          </a:ln>
        </p:spPr>
      </p:pic>
      <p:pic>
        <p:nvPicPr>
          <p:cNvPr id="199" name="Εικόνα 208" descr=""/>
          <p:cNvPicPr/>
          <p:nvPr/>
        </p:nvPicPr>
        <p:blipFill>
          <a:blip r:embed="rId26"/>
          <a:stretch/>
        </p:blipFill>
        <p:spPr>
          <a:xfrm>
            <a:off x="23220360" y="3564000"/>
            <a:ext cx="1146240" cy="971640"/>
          </a:xfrm>
          <a:prstGeom prst="rect">
            <a:avLst/>
          </a:prstGeom>
          <a:ln w="0">
            <a:noFill/>
          </a:ln>
        </p:spPr>
      </p:pic>
      <p:pic>
        <p:nvPicPr>
          <p:cNvPr id="200" name="Picture 380" descr="Icon&#10;&#10;Description automatically generated"/>
          <p:cNvPicPr/>
          <p:nvPr/>
        </p:nvPicPr>
        <p:blipFill>
          <a:blip r:embed="rId27"/>
          <a:stretch/>
        </p:blipFill>
        <p:spPr>
          <a:xfrm>
            <a:off x="21815280" y="4527720"/>
            <a:ext cx="573120" cy="609480"/>
          </a:xfrm>
          <a:prstGeom prst="rect">
            <a:avLst/>
          </a:prstGeom>
          <a:ln w="0">
            <a:noFill/>
          </a:ln>
        </p:spPr>
      </p:pic>
      <p:pic>
        <p:nvPicPr>
          <p:cNvPr id="201" name="Picture 380" descr="Icon&#10;&#10;Description automatically generated"/>
          <p:cNvPicPr/>
          <p:nvPr/>
        </p:nvPicPr>
        <p:blipFill>
          <a:blip r:embed="rId28"/>
          <a:stretch/>
        </p:blipFill>
        <p:spPr>
          <a:xfrm>
            <a:off x="22628160" y="4581360"/>
            <a:ext cx="571680" cy="613080"/>
          </a:xfrm>
          <a:prstGeom prst="rect">
            <a:avLst/>
          </a:prstGeom>
          <a:ln w="0">
            <a:noFill/>
          </a:ln>
        </p:spPr>
      </p:pic>
      <p:pic>
        <p:nvPicPr>
          <p:cNvPr id="202" name="Picture 380" descr="Icon&#10;&#10;Description automatically generated"/>
          <p:cNvPicPr/>
          <p:nvPr/>
        </p:nvPicPr>
        <p:blipFill>
          <a:blip r:embed="rId29"/>
          <a:stretch/>
        </p:blipFill>
        <p:spPr>
          <a:xfrm>
            <a:off x="23614200" y="4527720"/>
            <a:ext cx="571320" cy="609480"/>
          </a:xfrm>
          <a:prstGeom prst="rect">
            <a:avLst/>
          </a:prstGeom>
          <a:ln w="0">
            <a:noFill/>
          </a:ln>
        </p:spPr>
      </p:pic>
      <p:sp>
        <p:nvSpPr>
          <p:cNvPr id="203" name="TextBox 396"/>
          <p:cNvSpPr/>
          <p:nvPr/>
        </p:nvSpPr>
        <p:spPr>
          <a:xfrm>
            <a:off x="3519360" y="4459320"/>
            <a:ext cx="110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Arial"/>
              </a:rPr>
              <a:t>Splee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Straight Connector 278"/>
          <p:cNvSpPr/>
          <p:nvPr/>
        </p:nvSpPr>
        <p:spPr>
          <a:xfrm flipH="1">
            <a:off x="14747400" y="2668680"/>
            <a:ext cx="436680" cy="1299960"/>
          </a:xfrm>
          <a:prstGeom prst="line">
            <a:avLst/>
          </a:prstGeom>
          <a:ln w="190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Box 234"/>
          <p:cNvSpPr/>
          <p:nvPr/>
        </p:nvSpPr>
        <p:spPr>
          <a:xfrm>
            <a:off x="15079680" y="3621240"/>
            <a:ext cx="227340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Arial"/>
              </a:rPr>
              <a:t>Screening by ELIS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6" name="Εικόνα 18" descr=""/>
          <p:cNvPicPr/>
          <p:nvPr/>
        </p:nvPicPr>
        <p:blipFill>
          <a:blip r:embed="rId30"/>
          <a:srcRect l="4474" t="0" r="0" b="0"/>
          <a:stretch/>
        </p:blipFill>
        <p:spPr>
          <a:xfrm>
            <a:off x="16675200" y="4424400"/>
            <a:ext cx="3760560" cy="2098800"/>
          </a:xfrm>
          <a:prstGeom prst="rect">
            <a:avLst/>
          </a:prstGeom>
          <a:ln w="0">
            <a:noFill/>
          </a:ln>
        </p:spPr>
      </p:pic>
      <p:pic>
        <p:nvPicPr>
          <p:cNvPr id="207" name="Εικόνα 2" descr=""/>
          <p:cNvPicPr/>
          <p:nvPr/>
        </p:nvPicPr>
        <p:blipFill>
          <a:blip r:embed="rId31"/>
          <a:srcRect l="0" t="6651" r="0" b="0"/>
          <a:stretch/>
        </p:blipFill>
        <p:spPr>
          <a:xfrm>
            <a:off x="18083160" y="1096920"/>
            <a:ext cx="2441520" cy="3332160"/>
          </a:xfrm>
          <a:prstGeom prst="rect">
            <a:avLst/>
          </a:prstGeom>
          <a:ln w="0">
            <a:noFill/>
          </a:ln>
        </p:spPr>
      </p:pic>
      <p:sp>
        <p:nvSpPr>
          <p:cNvPr id="208" name="Right Arrow 147"/>
          <p:cNvSpPr/>
          <p:nvPr/>
        </p:nvSpPr>
        <p:spPr>
          <a:xfrm>
            <a:off x="15352560" y="4024440"/>
            <a:ext cx="1500480" cy="479160"/>
          </a:xfrm>
          <a:prstGeom prst="rightArrow">
            <a:avLst>
              <a:gd name="adj1" fmla="val 50000"/>
              <a:gd name="adj2" fmla="val 50118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Right Arrow 147"/>
          <p:cNvSpPr/>
          <p:nvPr/>
        </p:nvSpPr>
        <p:spPr>
          <a:xfrm>
            <a:off x="24807960" y="4156200"/>
            <a:ext cx="868320" cy="519120"/>
          </a:xfrm>
          <a:prstGeom prst="rightArrow">
            <a:avLst>
              <a:gd name="adj1" fmla="val 50000"/>
              <a:gd name="adj2" fmla="val 50010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0" name="Ομάδα 6"/>
          <p:cNvGrpSpPr/>
          <p:nvPr/>
        </p:nvGrpSpPr>
        <p:grpSpPr>
          <a:xfrm>
            <a:off x="20894760" y="7705800"/>
            <a:ext cx="6505560" cy="2482920"/>
            <a:chOff x="20894760" y="7705800"/>
            <a:chExt cx="6505560" cy="2482920"/>
          </a:xfrm>
        </p:grpSpPr>
        <p:sp>
          <p:nvSpPr>
            <p:cNvPr id="211" name="Βέλος: Διάσημα 237"/>
            <p:cNvSpPr/>
            <p:nvPr/>
          </p:nvSpPr>
          <p:spPr>
            <a:xfrm>
              <a:off x="20894760" y="7705800"/>
              <a:ext cx="6505560" cy="2343960"/>
            </a:xfrm>
            <a:custGeom>
              <a:avLst/>
              <a:gdLst>
                <a:gd name="textAreaLeft" fmla="*/ 0 w 6505560"/>
                <a:gd name="textAreaRight" fmla="*/ 6505920 w 6505560"/>
                <a:gd name="textAreaTop" fmla="*/ 0 h 2343960"/>
                <a:gd name="textAreaBottom" fmla="*/ 2344320 h 2343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7709" y="0"/>
                  </a:lnTo>
                  <a:lnTo>
                    <a:pt x="21600" y="10800"/>
                  </a:lnTo>
                  <a:lnTo>
                    <a:pt x="17709" y="21600"/>
                  </a:lnTo>
                  <a:lnTo>
                    <a:pt x="0" y="21600"/>
                  </a:lnTo>
                  <a:lnTo>
                    <a:pt x="3891" y="10800"/>
                  </a:lnTo>
                  <a:close/>
                </a:path>
              </a:pathLst>
            </a:custGeom>
            <a:solidFill>
              <a:srgbClr val="92d050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Βέλος: Διάσημα 4"/>
            <p:cNvSpPr/>
            <p:nvPr/>
          </p:nvSpPr>
          <p:spPr>
            <a:xfrm>
              <a:off x="21695400" y="7844760"/>
              <a:ext cx="5253480" cy="234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19880" rIns="39960" tIns="79920" bIns="79920" anchor="ctr">
              <a:noAutofit/>
            </a:bodyPr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r>
                <a:rPr b="1" lang="en-GB" sz="2500" spc="-1" strike="noStrike" baseline="30000">
                  <a:solidFill>
                    <a:srgbClr val="000000"/>
                  </a:solidFill>
                  <a:latin typeface="Calibri"/>
                </a:rPr>
                <a:t>th</a:t>
              </a: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  Screening: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US" sz="2500" spc="-1" strike="noStrike">
                  <a:solidFill>
                    <a:srgbClr val="000000"/>
                  </a:solidFill>
                  <a:latin typeface="Calibri"/>
                </a:rPr>
                <a:t>8 optimum clones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Highest SARS-CoV-2 Affinity Clone</a:t>
              </a:r>
              <a:r>
                <a:rPr b="0" lang="en-GB" sz="2500" spc="-1" strike="noStrike">
                  <a:solidFill>
                    <a:srgbClr val="000000"/>
                  </a:solidFill>
                  <a:latin typeface="Calibri"/>
                </a:rPr>
                <a:t>: </a:t>
              </a: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G2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3" name="Ομάδα 5"/>
          <p:cNvGrpSpPr/>
          <p:nvPr/>
        </p:nvGrpSpPr>
        <p:grpSpPr>
          <a:xfrm>
            <a:off x="16476840" y="7661160"/>
            <a:ext cx="5252760" cy="2400480"/>
            <a:chOff x="16476840" y="7661160"/>
            <a:chExt cx="5252760" cy="2400480"/>
          </a:xfrm>
        </p:grpSpPr>
        <p:sp>
          <p:nvSpPr>
            <p:cNvPr id="214" name="Βέλος: Διάσημα 240"/>
            <p:cNvSpPr/>
            <p:nvPr/>
          </p:nvSpPr>
          <p:spPr>
            <a:xfrm>
              <a:off x="16476840" y="7661160"/>
              <a:ext cx="5252760" cy="2345040"/>
            </a:xfrm>
            <a:custGeom>
              <a:avLst/>
              <a:gdLst>
                <a:gd name="textAreaLeft" fmla="*/ 0 w 5252760"/>
                <a:gd name="textAreaRight" fmla="*/ 5253120 w 5252760"/>
                <a:gd name="textAreaTop" fmla="*/ 0 h 2345040"/>
                <a:gd name="textAreaBottom" fmla="*/ 2345400 h 2345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782" y="0"/>
                  </a:lnTo>
                  <a:lnTo>
                    <a:pt x="21600" y="10800"/>
                  </a:lnTo>
                  <a:lnTo>
                    <a:pt x="16782" y="21600"/>
                  </a:lnTo>
                  <a:lnTo>
                    <a:pt x="0" y="21600"/>
                  </a:lnTo>
                  <a:lnTo>
                    <a:pt x="4818" y="10800"/>
                  </a:lnTo>
                  <a:close/>
                </a:path>
              </a:pathLst>
            </a:custGeom>
            <a:solidFill>
              <a:srgbClr val="c7e7a3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Βέλος: Διάσημα 4"/>
            <p:cNvSpPr/>
            <p:nvPr/>
          </p:nvSpPr>
          <p:spPr>
            <a:xfrm>
              <a:off x="17608680" y="7716600"/>
              <a:ext cx="3536640" cy="234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19880" rIns="39960" tIns="79920" bIns="79920" anchor="ctr">
              <a:noAutofit/>
            </a:bodyPr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r>
                <a:rPr b="1" lang="en-GB" sz="2500" spc="-1" strike="noStrike" baseline="30000">
                  <a:solidFill>
                    <a:srgbClr val="000000"/>
                  </a:solidFill>
                  <a:latin typeface="Calibri"/>
                </a:rPr>
                <a:t>th</a:t>
              </a: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  Screening: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47 </a:t>
              </a:r>
              <a:r>
                <a:rPr b="1" lang="en-US" sz="2500" spc="-1" strike="noStrike">
                  <a:solidFill>
                    <a:srgbClr val="000000"/>
                  </a:solidFill>
                  <a:latin typeface="Calibri"/>
                </a:rPr>
                <a:t>clones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6" name="Ομάδα 4"/>
          <p:cNvGrpSpPr/>
          <p:nvPr/>
        </p:nvGrpSpPr>
        <p:grpSpPr>
          <a:xfrm>
            <a:off x="12546000" y="7682040"/>
            <a:ext cx="4803840" cy="2433600"/>
            <a:chOff x="12546000" y="7682040"/>
            <a:chExt cx="4803840" cy="2433600"/>
          </a:xfrm>
        </p:grpSpPr>
        <p:sp>
          <p:nvSpPr>
            <p:cNvPr id="217" name="Βέλος: Διάσημα 243"/>
            <p:cNvSpPr/>
            <p:nvPr/>
          </p:nvSpPr>
          <p:spPr>
            <a:xfrm>
              <a:off x="12546000" y="7682040"/>
              <a:ext cx="4803840" cy="2367000"/>
            </a:xfrm>
            <a:custGeom>
              <a:avLst/>
              <a:gdLst>
                <a:gd name="textAreaLeft" fmla="*/ 0 w 4803840"/>
                <a:gd name="textAreaRight" fmla="*/ 4803840 w 4803840"/>
                <a:gd name="textAreaTop" fmla="*/ 0 h 2367000"/>
                <a:gd name="textAreaBottom" fmla="*/ 2367360 h 2367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79" y="0"/>
                  </a:lnTo>
                  <a:lnTo>
                    <a:pt x="21600" y="10800"/>
                  </a:lnTo>
                  <a:lnTo>
                    <a:pt x="16279" y="21600"/>
                  </a:lnTo>
                  <a:lnTo>
                    <a:pt x="0" y="21600"/>
                  </a:lnTo>
                  <a:lnTo>
                    <a:pt x="5321" y="10800"/>
                  </a:lnTo>
                  <a:close/>
                </a:path>
              </a:pathLst>
            </a:custGeom>
            <a:solidFill>
              <a:srgbClr val="ff9b9b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Βέλος: Διάσημα 4"/>
            <p:cNvSpPr/>
            <p:nvPr/>
          </p:nvSpPr>
          <p:spPr>
            <a:xfrm>
              <a:off x="13600800" y="7748640"/>
              <a:ext cx="2694240" cy="2367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19880" rIns="39960" tIns="79920" bIns="79920" anchor="ctr">
              <a:noAutofit/>
            </a:bodyPr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r>
                <a:rPr b="1" lang="en-GB" sz="2500" spc="-1" strike="noStrike" baseline="30000">
                  <a:solidFill>
                    <a:srgbClr val="000000"/>
                  </a:solidFill>
                  <a:latin typeface="Calibri"/>
                </a:rPr>
                <a:t>rd</a:t>
              </a: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 Screening: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93 </a:t>
              </a:r>
              <a:r>
                <a:rPr b="1" lang="en-US" sz="2500" spc="-1" strike="noStrike">
                  <a:solidFill>
                    <a:srgbClr val="000000"/>
                  </a:solidFill>
                  <a:latin typeface="Calibri"/>
                </a:rPr>
                <a:t>clones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9" name="Ομάδα 3"/>
          <p:cNvGrpSpPr/>
          <p:nvPr/>
        </p:nvGrpSpPr>
        <p:grpSpPr>
          <a:xfrm>
            <a:off x="9209160" y="7605720"/>
            <a:ext cx="4146480" cy="2489040"/>
            <a:chOff x="9209160" y="7605720"/>
            <a:chExt cx="4146480" cy="2489040"/>
          </a:xfrm>
        </p:grpSpPr>
        <p:sp>
          <p:nvSpPr>
            <p:cNvPr id="220" name="Βέλος: Διάσημα 246"/>
            <p:cNvSpPr/>
            <p:nvPr/>
          </p:nvSpPr>
          <p:spPr>
            <a:xfrm>
              <a:off x="9209160" y="7683120"/>
              <a:ext cx="4146480" cy="2411640"/>
            </a:xfrm>
            <a:custGeom>
              <a:avLst/>
              <a:gdLst>
                <a:gd name="textAreaLeft" fmla="*/ 0 w 4146480"/>
                <a:gd name="textAreaRight" fmla="*/ 4146840 w 4146480"/>
                <a:gd name="textAreaTop" fmla="*/ 0 h 2411640"/>
                <a:gd name="textAreaBottom" fmla="*/ 2412000 h 2411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321" y="0"/>
                  </a:lnTo>
                  <a:lnTo>
                    <a:pt x="21600" y="10800"/>
                  </a:lnTo>
                  <a:lnTo>
                    <a:pt x="15321" y="21600"/>
                  </a:lnTo>
                  <a:lnTo>
                    <a:pt x="0" y="21600"/>
                  </a:lnTo>
                  <a:lnTo>
                    <a:pt x="6279" y="10800"/>
                  </a:lnTo>
                  <a:close/>
                </a:path>
              </a:pathLst>
            </a:custGeom>
            <a:solidFill>
              <a:srgbClr val="ff6565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Βέλος: Διάσημα 4"/>
            <p:cNvSpPr/>
            <p:nvPr/>
          </p:nvSpPr>
          <p:spPr>
            <a:xfrm>
              <a:off x="9837720" y="7605720"/>
              <a:ext cx="3377160" cy="241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19880" rIns="39960" tIns="79920" bIns="79920" anchor="ctr">
              <a:noAutofit/>
            </a:bodyPr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1" lang="en-GB" sz="2500" spc="-1" strike="noStrike" baseline="30000">
                  <a:solidFill>
                    <a:srgbClr val="000000"/>
                  </a:solidFill>
                  <a:latin typeface="Calibri"/>
                </a:rPr>
                <a:t>nd</a:t>
              </a:r>
              <a:r>
                <a:rPr b="0" lang="en-GB" sz="2500" spc="-1" strike="noStrike">
                  <a:solidFill>
                    <a:srgbClr val="ffffff"/>
                  </a:solidFill>
                  <a:latin typeface="Calibri"/>
                </a:rPr>
                <a:t> </a:t>
              </a: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Screening: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1332000"/>
                  <a:tab algn="l" pos="2664000"/>
                  <a:tab algn="l" pos="3995640"/>
                  <a:tab algn="l" pos="5327640"/>
                  <a:tab algn="l" pos="6659640"/>
                  <a:tab algn="l" pos="7991640"/>
                  <a:tab algn="l" pos="9323280"/>
                  <a:tab algn="l" pos="1065528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189 </a:t>
              </a:r>
              <a:r>
                <a:rPr b="1" lang="en-US" sz="2500" spc="-1" strike="noStrike">
                  <a:solidFill>
                    <a:srgbClr val="000000"/>
                  </a:solidFill>
                  <a:latin typeface="Calibri"/>
                </a:rPr>
                <a:t>Clones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2" name="Ομάδα 2"/>
          <p:cNvGrpSpPr/>
          <p:nvPr/>
        </p:nvGrpSpPr>
        <p:grpSpPr>
          <a:xfrm>
            <a:off x="5946840" y="7632720"/>
            <a:ext cx="4147920" cy="2421000"/>
            <a:chOff x="5946840" y="7632720"/>
            <a:chExt cx="4147920" cy="2421000"/>
          </a:xfrm>
        </p:grpSpPr>
        <p:sp>
          <p:nvSpPr>
            <p:cNvPr id="223" name="Βέλος: Διάσημα 249"/>
            <p:cNvSpPr/>
            <p:nvPr/>
          </p:nvSpPr>
          <p:spPr>
            <a:xfrm>
              <a:off x="5946840" y="7632720"/>
              <a:ext cx="4147920" cy="2421000"/>
            </a:xfrm>
            <a:custGeom>
              <a:avLst/>
              <a:gdLst>
                <a:gd name="textAreaLeft" fmla="*/ 0 w 4147920"/>
                <a:gd name="textAreaRight" fmla="*/ 4148280 w 4147920"/>
                <a:gd name="textAreaTop" fmla="*/ 0 h 2421000"/>
                <a:gd name="textAreaBottom" fmla="*/ 2421360 h 2421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293" y="0"/>
                  </a:lnTo>
                  <a:lnTo>
                    <a:pt x="21600" y="10800"/>
                  </a:lnTo>
                  <a:lnTo>
                    <a:pt x="15293" y="21600"/>
                  </a:lnTo>
                  <a:lnTo>
                    <a:pt x="0" y="21600"/>
                  </a:lnTo>
                  <a:lnTo>
                    <a:pt x="6307" y="10800"/>
                  </a:lnTo>
                  <a:close/>
                </a:path>
              </a:pathLst>
            </a:custGeom>
            <a:solidFill>
              <a:srgbClr val="f20000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Βέλος: Διάσημα 4"/>
            <p:cNvSpPr/>
            <p:nvPr/>
          </p:nvSpPr>
          <p:spPr>
            <a:xfrm>
              <a:off x="6653160" y="7844760"/>
              <a:ext cx="3123000" cy="198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7880" rIns="15840" tIns="32040" bIns="32040" anchor="ctr">
              <a:noAutofit/>
            </a:bodyPr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531720"/>
                  <a:tab algn="l" pos="1063800"/>
                  <a:tab algn="l" pos="1595520"/>
                  <a:tab algn="l" pos="2127240"/>
                  <a:tab algn="l" pos="2658960"/>
                  <a:tab algn="l" pos="3191040"/>
                  <a:tab algn="l" pos="3722760"/>
                  <a:tab algn="l" pos="4254480"/>
                  <a:tab algn="l" pos="4786200"/>
                  <a:tab algn="l" pos="5318280"/>
                  <a:tab algn="l" pos="5850000"/>
                  <a:tab algn="l" pos="6381720"/>
                  <a:tab algn="l" pos="6913440"/>
                  <a:tab algn="l" pos="7445520"/>
                  <a:tab algn="l" pos="7977240"/>
                  <a:tab algn="l" pos="8508960"/>
                  <a:tab algn="l" pos="9040680"/>
                  <a:tab algn="l" pos="9572760"/>
                  <a:tab algn="l" pos="10104480"/>
                  <a:tab algn="l" pos="1063620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r>
                <a:rPr b="1" lang="en-GB" sz="2500" spc="-1" strike="noStrike" baseline="30000">
                  <a:solidFill>
                    <a:srgbClr val="000000"/>
                  </a:solidFill>
                  <a:latin typeface="Calibri"/>
                </a:rPr>
                <a:t>st</a:t>
              </a: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 Screening: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531720"/>
                  <a:tab algn="l" pos="1063800"/>
                  <a:tab algn="l" pos="1595520"/>
                  <a:tab algn="l" pos="2127240"/>
                  <a:tab algn="l" pos="2658960"/>
                  <a:tab algn="l" pos="3191040"/>
                  <a:tab algn="l" pos="3722760"/>
                  <a:tab algn="l" pos="4254480"/>
                  <a:tab algn="l" pos="4786200"/>
                  <a:tab algn="l" pos="5318280"/>
                  <a:tab algn="l" pos="5850000"/>
                  <a:tab algn="l" pos="6381720"/>
                  <a:tab algn="l" pos="6913440"/>
                  <a:tab algn="l" pos="7445520"/>
                  <a:tab algn="l" pos="7977240"/>
                  <a:tab algn="l" pos="8508960"/>
                  <a:tab algn="l" pos="9040680"/>
                  <a:tab algn="l" pos="9572760"/>
                  <a:tab algn="l" pos="10104480"/>
                  <a:tab algn="l" pos="10636200"/>
                </a:tabLst>
              </a:pPr>
              <a:r>
                <a:rPr b="1" lang="en-GB" sz="2500" spc="-1" strike="noStrike">
                  <a:solidFill>
                    <a:srgbClr val="000000"/>
                  </a:solidFill>
                  <a:latin typeface="Calibri"/>
                </a:rPr>
                <a:t>710 </a:t>
              </a:r>
              <a:r>
                <a:rPr b="1" lang="en-US" sz="2500" spc="-1" strike="noStrike">
                  <a:solidFill>
                    <a:srgbClr val="000000"/>
                  </a:solidFill>
                  <a:latin typeface="Calibri"/>
                </a:rPr>
                <a:t>Clones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5" name="Ομάδα 1"/>
          <p:cNvGrpSpPr/>
          <p:nvPr/>
        </p:nvGrpSpPr>
        <p:grpSpPr>
          <a:xfrm>
            <a:off x="3713040" y="7621560"/>
            <a:ext cx="3095640" cy="2489400"/>
            <a:chOff x="3713040" y="7621560"/>
            <a:chExt cx="3095640" cy="2489400"/>
          </a:xfrm>
        </p:grpSpPr>
        <p:sp>
          <p:nvSpPr>
            <p:cNvPr id="226" name="Βέλος: Πεντάγωνο 252"/>
            <p:cNvSpPr/>
            <p:nvPr/>
          </p:nvSpPr>
          <p:spPr>
            <a:xfrm>
              <a:off x="3713040" y="7621560"/>
              <a:ext cx="3095640" cy="2489400"/>
            </a:xfrm>
            <a:custGeom>
              <a:avLst/>
              <a:gdLst>
                <a:gd name="textAreaLeft" fmla="*/ 0 w 3095640"/>
                <a:gd name="textAreaRight" fmla="*/ 3096000 w 3095640"/>
                <a:gd name="textAreaTop" fmla="*/ 0 h 2489400"/>
                <a:gd name="textAreaBottom" fmla="*/ 2489760 h 2489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2918" y="0"/>
                  </a:lnTo>
                  <a:lnTo>
                    <a:pt x="21600" y="10800"/>
                  </a:lnTo>
                  <a:lnTo>
                    <a:pt x="12918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c00000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Βέλος: Πεντάγωνο 4"/>
            <p:cNvSpPr/>
            <p:nvPr/>
          </p:nvSpPr>
          <p:spPr>
            <a:xfrm>
              <a:off x="3713040" y="7621560"/>
              <a:ext cx="2669040" cy="248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4080" rIns="15840" tIns="32040" bIns="32040" anchor="ctr">
              <a:noAutofit/>
            </a:bodyPr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531720"/>
                  <a:tab algn="l" pos="1063800"/>
                  <a:tab algn="l" pos="1595520"/>
                  <a:tab algn="l" pos="2127240"/>
                  <a:tab algn="l" pos="2658960"/>
                  <a:tab algn="l" pos="3191040"/>
                  <a:tab algn="l" pos="3722760"/>
                  <a:tab algn="l" pos="4254480"/>
                  <a:tab algn="l" pos="4786200"/>
                  <a:tab algn="l" pos="5318280"/>
                  <a:tab algn="l" pos="5850000"/>
                  <a:tab algn="l" pos="6381720"/>
                  <a:tab algn="l" pos="6913440"/>
                  <a:tab algn="l" pos="7445520"/>
                  <a:tab algn="l" pos="7977240"/>
                  <a:tab algn="l" pos="8508960"/>
                  <a:tab algn="l" pos="9040680"/>
                  <a:tab algn="l" pos="9572760"/>
                  <a:tab algn="l" pos="10104480"/>
                  <a:tab algn="l" pos="10636200"/>
                </a:tabLst>
              </a:pPr>
              <a:r>
                <a:rPr b="1" lang="en-GB" sz="2500" spc="-1" strike="noStrike">
                  <a:solidFill>
                    <a:srgbClr val="ffffff"/>
                  </a:solidFill>
                  <a:latin typeface="Calibri"/>
                </a:rPr>
                <a:t>1582 Clones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90000"/>
                </a:lnSpc>
                <a:spcAft>
                  <a:spcPts val="1089"/>
                </a:spcAft>
                <a:tabLst>
                  <a:tab algn="l" pos="0"/>
                  <a:tab algn="l" pos="531720"/>
                  <a:tab algn="l" pos="1063800"/>
                  <a:tab algn="l" pos="1595520"/>
                  <a:tab algn="l" pos="2127240"/>
                  <a:tab algn="l" pos="2658960"/>
                  <a:tab algn="l" pos="3191040"/>
                  <a:tab algn="l" pos="3722760"/>
                  <a:tab algn="l" pos="4254480"/>
                  <a:tab algn="l" pos="4786200"/>
                  <a:tab algn="l" pos="5318280"/>
                  <a:tab algn="l" pos="5850000"/>
                  <a:tab algn="l" pos="6381720"/>
                  <a:tab algn="l" pos="6913440"/>
                  <a:tab algn="l" pos="7445520"/>
                  <a:tab algn="l" pos="7977240"/>
                  <a:tab algn="l" pos="8508960"/>
                  <a:tab algn="l" pos="9040680"/>
                  <a:tab algn="l" pos="9572760"/>
                  <a:tab algn="l" pos="10104480"/>
                  <a:tab algn="l" pos="10636200"/>
                </a:tabLst>
              </a:pPr>
              <a:r>
                <a:rPr b="1" lang="en-GB" sz="2500" spc="-1" strike="noStrike">
                  <a:solidFill>
                    <a:srgbClr val="ffffff"/>
                  </a:solidFill>
                  <a:latin typeface="Calibri"/>
                </a:rPr>
                <a:t>Generated </a:t>
              </a:r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8" name="Straight Connector 395"/>
          <p:cNvSpPr/>
          <p:nvPr/>
        </p:nvSpPr>
        <p:spPr>
          <a:xfrm flipH="1">
            <a:off x="3676320" y="5670720"/>
            <a:ext cx="6157800" cy="2055600"/>
          </a:xfrm>
          <a:prstGeom prst="line">
            <a:avLst/>
          </a:prstGeom>
          <a:ln w="255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Straight Connector 395"/>
          <p:cNvSpPr/>
          <p:nvPr/>
        </p:nvSpPr>
        <p:spPr>
          <a:xfrm flipH="1">
            <a:off x="27399960" y="6861240"/>
            <a:ext cx="530280" cy="1989000"/>
          </a:xfrm>
          <a:prstGeom prst="line">
            <a:avLst/>
          </a:prstGeom>
          <a:ln w="255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0" name="Εικόνα 265" descr=""/>
          <p:cNvPicPr/>
          <p:nvPr/>
        </p:nvPicPr>
        <p:blipFill>
          <a:blip r:embed="rId32"/>
          <a:stretch/>
        </p:blipFill>
        <p:spPr>
          <a:xfrm>
            <a:off x="17187840" y="11291760"/>
            <a:ext cx="10399680" cy="61754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31" name="Right Arrow 147"/>
          <p:cNvSpPr/>
          <p:nvPr/>
        </p:nvSpPr>
        <p:spPr>
          <a:xfrm>
            <a:off x="19780200" y="4006800"/>
            <a:ext cx="1214640" cy="459000"/>
          </a:xfrm>
          <a:prstGeom prst="rightArrow">
            <a:avLst>
              <a:gd name="adj1" fmla="val 50000"/>
              <a:gd name="adj2" fmla="val 50144"/>
            </a:avLst>
          </a:prstGeom>
          <a:solidFill>
            <a:srgbClr val="adb9ca"/>
          </a:solidFill>
          <a:ln w="12600">
            <a:solidFill>
              <a:srgbClr val="2f528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1494000"/>
                <a:tab algn="l" pos="2987640"/>
                <a:tab algn="l" pos="4481640"/>
                <a:tab algn="l" pos="5975280"/>
                <a:tab algn="l" pos="7469280"/>
                <a:tab algn="l" pos="8962920"/>
                <a:tab algn="l" pos="104569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Straight Connector 395"/>
          <p:cNvSpPr/>
          <p:nvPr/>
        </p:nvSpPr>
        <p:spPr>
          <a:xfrm flipH="1">
            <a:off x="1366560" y="10037880"/>
            <a:ext cx="19778760" cy="1544400"/>
          </a:xfrm>
          <a:prstGeom prst="line">
            <a:avLst/>
          </a:prstGeom>
          <a:ln w="255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Straight Connector 395"/>
          <p:cNvSpPr/>
          <p:nvPr/>
        </p:nvSpPr>
        <p:spPr>
          <a:xfrm>
            <a:off x="26312760" y="10063080"/>
            <a:ext cx="1271520" cy="1187640"/>
          </a:xfrm>
          <a:prstGeom prst="line">
            <a:avLst/>
          </a:prstGeom>
          <a:ln w="255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4" name="Picture 2" descr="C:\Users\Admin\Desktop\107463560_270239954201566_96280232993437666_n.jpg"/>
          <p:cNvPicPr/>
          <p:nvPr/>
        </p:nvPicPr>
        <p:blipFill>
          <a:blip r:embed="rId33"/>
          <a:srcRect l="1176" t="6949" r="1964" b="6949"/>
          <a:stretch/>
        </p:blipFill>
        <p:spPr>
          <a:xfrm>
            <a:off x="1413000" y="11717280"/>
            <a:ext cx="5443560" cy="34909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235" name=""/>
          <p:cNvGraphicFramePr/>
          <p:nvPr/>
        </p:nvGraphicFramePr>
        <p:xfrm>
          <a:off x="7311960" y="14506560"/>
          <a:ext cx="9574200" cy="2982960"/>
        </p:xfrm>
        <a:graphic>
          <a:graphicData uri="http://schemas.openxmlformats.org/drawingml/2006/table">
            <a:tbl>
              <a:tblPr/>
              <a:tblGrid>
                <a:gridCol w="736560"/>
                <a:gridCol w="736560"/>
                <a:gridCol w="736920"/>
                <a:gridCol w="736560"/>
                <a:gridCol w="734760"/>
                <a:gridCol w="736560"/>
                <a:gridCol w="736920"/>
                <a:gridCol w="736560"/>
                <a:gridCol w="736560"/>
                <a:gridCol w="736560"/>
                <a:gridCol w="736560"/>
                <a:gridCol w="736560"/>
                <a:gridCol w="736560"/>
              </a:tblGrid>
              <a:tr h="33660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32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2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9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1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076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64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05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8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2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3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7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0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9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75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24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5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25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1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1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6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3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6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9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3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2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6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6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04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8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4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713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17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51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65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265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5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324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1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999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26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77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42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l-GR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98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236" name=""/>
          <p:cNvGraphicFramePr/>
          <p:nvPr/>
        </p:nvGraphicFramePr>
        <p:xfrm>
          <a:off x="7311960" y="11290320"/>
          <a:ext cx="9574200" cy="3116160"/>
        </p:xfrm>
        <a:graphic>
          <a:graphicData uri="http://schemas.openxmlformats.org/drawingml/2006/table">
            <a:tbl>
              <a:tblPr/>
              <a:tblGrid>
                <a:gridCol w="736560"/>
                <a:gridCol w="736560"/>
                <a:gridCol w="736920"/>
                <a:gridCol w="736560"/>
                <a:gridCol w="734760"/>
                <a:gridCol w="736560"/>
                <a:gridCol w="736920"/>
                <a:gridCol w="736560"/>
                <a:gridCol w="736560"/>
                <a:gridCol w="736560"/>
                <a:gridCol w="736560"/>
                <a:gridCol w="736560"/>
                <a:gridCol w="736560"/>
              </a:tblGrid>
              <a:tr h="34596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B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B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B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B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B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B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632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596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596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632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596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596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632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  <a:tr h="34740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LANK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158920"/>
                          <a:tab algn="l" pos="4317840"/>
                          <a:tab algn="l" pos="6477120"/>
                          <a:tab algn="l" pos="8636040"/>
                          <a:tab algn="l" pos="1079496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LANK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cccc"/>
                    </a:solidFill>
                  </a:tcPr>
                </a:tc>
              </a:tr>
            </a:tbl>
          </a:graphicData>
        </a:graphic>
      </p:graphicFrame>
      <p:sp>
        <p:nvSpPr>
          <p:cNvPr id="237" name="TextBox 242"/>
          <p:cNvSpPr/>
          <p:nvPr/>
        </p:nvSpPr>
        <p:spPr>
          <a:xfrm>
            <a:off x="412920" y="387360"/>
            <a:ext cx="71118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500" spc="-1" strike="noStrike">
                <a:solidFill>
                  <a:srgbClr val="000000"/>
                </a:solidFill>
                <a:latin typeface="Calibri"/>
                <a:ea typeface="Arial"/>
              </a:rPr>
              <a:t>Suppl Figure 1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TextBox 242"/>
          <p:cNvSpPr/>
          <p:nvPr/>
        </p:nvSpPr>
        <p:spPr>
          <a:xfrm>
            <a:off x="425520" y="973080"/>
            <a:ext cx="71118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500" spc="-1" strike="noStrike">
                <a:solidFill>
                  <a:srgbClr val="000000"/>
                </a:solidFill>
                <a:latin typeface="Calibri"/>
                <a:ea typeface="Arial"/>
              </a:rPr>
              <a:t>A.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242"/>
          <p:cNvSpPr/>
          <p:nvPr/>
        </p:nvSpPr>
        <p:spPr>
          <a:xfrm>
            <a:off x="426960" y="7350120"/>
            <a:ext cx="711216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500" spc="-1" strike="noStrike">
                <a:solidFill>
                  <a:srgbClr val="000000"/>
                </a:solidFill>
                <a:latin typeface="Calibri"/>
                <a:ea typeface="Arial"/>
              </a:rPr>
              <a:t>B.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Box 242"/>
          <p:cNvSpPr/>
          <p:nvPr/>
        </p:nvSpPr>
        <p:spPr>
          <a:xfrm>
            <a:off x="460440" y="10774440"/>
            <a:ext cx="71136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500" spc="-1" strike="noStrike">
                <a:solidFill>
                  <a:srgbClr val="000000"/>
                </a:solidFill>
                <a:latin typeface="Calibri"/>
                <a:ea typeface="Arial"/>
              </a:rPr>
              <a:t>C.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5-11T13:09:46Z</dcterms:created>
  <dc:creator>Nefeli Lagopati</dc:creator>
  <dc:description/>
  <dc:language>en-US</dc:language>
  <cp:lastModifiedBy>Evangelou</cp:lastModifiedBy>
  <dcterms:modified xsi:type="dcterms:W3CDTF">2021-05-11T19:16:55Z</dcterms:modified>
  <cp:revision>8</cp:revision>
  <dc:subject/>
  <dc:title>Παρουσίαση του PowerPoint</dc:title>
</cp:coreProperties>
</file>